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3"/>
  </p:notesMasterIdLst>
  <p:sldIdLst>
    <p:sldId id="438" r:id="rId5"/>
    <p:sldId id="437" r:id="rId6"/>
    <p:sldId id="421" r:id="rId7"/>
    <p:sldId id="436" r:id="rId8"/>
    <p:sldId id="411" r:id="rId9"/>
    <p:sldId id="370" r:id="rId10"/>
    <p:sldId id="402" r:id="rId11"/>
    <p:sldId id="413" r:id="rId12"/>
  </p:sldIdLst>
  <p:sldSz cx="6858000" cy="9144000" type="letter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" userDrawn="1">
          <p15:clr>
            <a:srgbClr val="A4A3A4"/>
          </p15:clr>
        </p15:guide>
        <p15:guide id="2" pos="192" userDrawn="1">
          <p15:clr>
            <a:srgbClr val="A4A3A4"/>
          </p15:clr>
        </p15:guide>
        <p15:guide id="3" pos="4128" userDrawn="1">
          <p15:clr>
            <a:srgbClr val="A4A3A4"/>
          </p15:clr>
        </p15:guide>
        <p15:guide id="4" orient="horz" pos="5568" userDrawn="1">
          <p15:clr>
            <a:srgbClr val="A4A3A4"/>
          </p15:clr>
        </p15:guide>
        <p15:guide id="5" pos="3912" userDrawn="1">
          <p15:clr>
            <a:srgbClr val="A4A3A4"/>
          </p15:clr>
        </p15:guide>
        <p15:guide id="6" orient="horz" pos="34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onnelly, Ashley N" initials="CAN" lastIdx="2" clrIdx="0">
    <p:extLst>
      <p:ext uri="{19B8F6BF-5375-455C-9EA6-DF929625EA0E}">
        <p15:presenceInfo xmlns:p15="http://schemas.microsoft.com/office/powerpoint/2012/main" userId="S-1-5-21-484763869-1637723038-1801674531-26816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001"/>
    <a:srgbClr val="0000FF"/>
    <a:srgbClr val="00C000"/>
    <a:srgbClr val="AD08E3"/>
    <a:srgbClr val="008000"/>
    <a:srgbClr val="FF0000"/>
    <a:srgbClr val="55A0FB"/>
    <a:srgbClr val="F71480"/>
    <a:srgbClr val="0070C0"/>
    <a:srgbClr val="F6991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67" autoAdjust="0"/>
    <p:restoredTop sz="93441" autoAdjust="0"/>
  </p:normalViewPr>
  <p:slideViewPr>
    <p:cSldViewPr snapToGrid="0" showGuides="1">
      <p:cViewPr>
        <p:scale>
          <a:sx n="100" d="100"/>
          <a:sy n="100" d="100"/>
        </p:scale>
        <p:origin x="970" y="-2227"/>
      </p:cViewPr>
      <p:guideLst>
        <p:guide orient="horz" pos="192"/>
        <p:guide pos="192"/>
        <p:guide pos="4128"/>
        <p:guide orient="horz" pos="5568"/>
        <p:guide pos="3912"/>
        <p:guide orient="horz" pos="348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onnelly, Ashley N" userId="f98c3b42-ca58-4efb-bc7f-491d5980b7a9" providerId="ADAL" clId="{1DF4AF3F-6983-4E84-AF5B-817065518A35}"/>
    <pc:docChg chg="undo custSel addSld modSld sldOrd">
      <pc:chgData name="Connelly, Ashley N" userId="f98c3b42-ca58-4efb-bc7f-491d5980b7a9" providerId="ADAL" clId="{1DF4AF3F-6983-4E84-AF5B-817065518A35}" dt="2021-12-01T17:20:14.914" v="728" actId="20577"/>
      <pc:docMkLst>
        <pc:docMk/>
      </pc:docMkLst>
      <pc:sldChg chg="modSp mod">
        <pc:chgData name="Connelly, Ashley N" userId="f98c3b42-ca58-4efb-bc7f-491d5980b7a9" providerId="ADAL" clId="{1DF4AF3F-6983-4E84-AF5B-817065518A35}" dt="2021-12-01T17:20:05.473" v="726" actId="20577"/>
        <pc:sldMkLst>
          <pc:docMk/>
          <pc:sldMk cId="3081025213" sldId="370"/>
        </pc:sldMkLst>
        <pc:spChg chg="mod">
          <ac:chgData name="Connelly, Ashley N" userId="f98c3b42-ca58-4efb-bc7f-491d5980b7a9" providerId="ADAL" clId="{1DF4AF3F-6983-4E84-AF5B-817065518A35}" dt="2021-12-01T17:20:05.473" v="726" actId="20577"/>
          <ac:spMkLst>
            <pc:docMk/>
            <pc:sldMk cId="3081025213" sldId="370"/>
            <ac:spMk id="21" creationId="{00000000-0000-0000-0000-000000000000}"/>
          </ac:spMkLst>
        </pc:spChg>
        <pc:spChg chg="mod">
          <ac:chgData name="Connelly, Ashley N" userId="f98c3b42-ca58-4efb-bc7f-491d5980b7a9" providerId="ADAL" clId="{1DF4AF3F-6983-4E84-AF5B-817065518A35}" dt="2021-11-20T21:20:59.622" v="27"/>
          <ac:spMkLst>
            <pc:docMk/>
            <pc:sldMk cId="3081025213" sldId="370"/>
            <ac:spMk id="65" creationId="{00000000-0000-0000-0000-000000000000}"/>
          </ac:spMkLst>
        </pc:spChg>
        <pc:spChg chg="mod">
          <ac:chgData name="Connelly, Ashley N" userId="f98c3b42-ca58-4efb-bc7f-491d5980b7a9" providerId="ADAL" clId="{1DF4AF3F-6983-4E84-AF5B-817065518A35}" dt="2021-11-20T21:20:59.689" v="32"/>
          <ac:spMkLst>
            <pc:docMk/>
            <pc:sldMk cId="3081025213" sldId="370"/>
            <ac:spMk id="66" creationId="{00000000-0000-0000-0000-000000000000}"/>
          </ac:spMkLst>
        </pc:spChg>
        <pc:spChg chg="mod">
          <ac:chgData name="Connelly, Ashley N" userId="f98c3b42-ca58-4efb-bc7f-491d5980b7a9" providerId="ADAL" clId="{1DF4AF3F-6983-4E84-AF5B-817065518A35}" dt="2021-11-20T21:50:20.595" v="88"/>
          <ac:spMkLst>
            <pc:docMk/>
            <pc:sldMk cId="3081025213" sldId="370"/>
            <ac:spMk id="67" creationId="{00000000-0000-0000-0000-000000000000}"/>
          </ac:spMkLst>
        </pc:spChg>
        <pc:spChg chg="mod">
          <ac:chgData name="Connelly, Ashley N" userId="f98c3b42-ca58-4efb-bc7f-491d5980b7a9" providerId="ADAL" clId="{1DF4AF3F-6983-4E84-AF5B-817065518A35}" dt="2021-11-20T21:55:43.875" v="105"/>
          <ac:spMkLst>
            <pc:docMk/>
            <pc:sldMk cId="3081025213" sldId="370"/>
            <ac:spMk id="68" creationId="{00000000-0000-0000-0000-000000000000}"/>
          </ac:spMkLst>
        </pc:spChg>
        <pc:grpChg chg="mod">
          <ac:chgData name="Connelly, Ashley N" userId="f98c3b42-ca58-4efb-bc7f-491d5980b7a9" providerId="ADAL" clId="{1DF4AF3F-6983-4E84-AF5B-817065518A35}" dt="2021-11-20T21:55:43.875" v="105"/>
          <ac:grpSpMkLst>
            <pc:docMk/>
            <pc:sldMk cId="3081025213" sldId="370"/>
            <ac:grpSpMk id="4" creationId="{00000000-0000-0000-0000-000000000000}"/>
          </ac:grpSpMkLst>
        </pc:grpChg>
        <pc:grpChg chg="mod">
          <ac:chgData name="Connelly, Ashley N" userId="f98c3b42-ca58-4efb-bc7f-491d5980b7a9" providerId="ADAL" clId="{1DF4AF3F-6983-4E84-AF5B-817065518A35}" dt="2021-11-20T21:50:20.595" v="88"/>
          <ac:grpSpMkLst>
            <pc:docMk/>
            <pc:sldMk cId="3081025213" sldId="370"/>
            <ac:grpSpMk id="5" creationId="{00000000-0000-0000-0000-000000000000}"/>
          </ac:grpSpMkLst>
        </pc:grpChg>
        <pc:grpChg chg="mod">
          <ac:chgData name="Connelly, Ashley N" userId="f98c3b42-ca58-4efb-bc7f-491d5980b7a9" providerId="ADAL" clId="{1DF4AF3F-6983-4E84-AF5B-817065518A35}" dt="2021-11-20T21:20:59.689" v="32"/>
          <ac:grpSpMkLst>
            <pc:docMk/>
            <pc:sldMk cId="3081025213" sldId="370"/>
            <ac:grpSpMk id="6" creationId="{00000000-0000-0000-0000-000000000000}"/>
          </ac:grpSpMkLst>
        </pc:grpChg>
        <pc:grpChg chg="mod">
          <ac:chgData name="Connelly, Ashley N" userId="f98c3b42-ca58-4efb-bc7f-491d5980b7a9" providerId="ADAL" clId="{1DF4AF3F-6983-4E84-AF5B-817065518A35}" dt="2021-11-20T21:20:59.622" v="27"/>
          <ac:grpSpMkLst>
            <pc:docMk/>
            <pc:sldMk cId="3081025213" sldId="370"/>
            <ac:grpSpMk id="7" creationId="{00000000-0000-0000-0000-000000000000}"/>
          </ac:grpSpMkLst>
        </pc:grpChg>
        <pc:grpChg chg="mod">
          <ac:chgData name="Connelly, Ashley N" userId="f98c3b42-ca58-4efb-bc7f-491d5980b7a9" providerId="ADAL" clId="{1DF4AF3F-6983-4E84-AF5B-817065518A35}" dt="2021-11-20T21:20:59.622" v="27"/>
          <ac:grpSpMkLst>
            <pc:docMk/>
            <pc:sldMk cId="3081025213" sldId="370"/>
            <ac:grpSpMk id="35" creationId="{00000000-0000-0000-0000-000000000000}"/>
          </ac:grpSpMkLst>
        </pc:grpChg>
        <pc:grpChg chg="mod">
          <ac:chgData name="Connelly, Ashley N" userId="f98c3b42-ca58-4efb-bc7f-491d5980b7a9" providerId="ADAL" clId="{1DF4AF3F-6983-4E84-AF5B-817065518A35}" dt="2021-11-20T21:20:59.689" v="32"/>
          <ac:grpSpMkLst>
            <pc:docMk/>
            <pc:sldMk cId="3081025213" sldId="370"/>
            <ac:grpSpMk id="42" creationId="{00000000-0000-0000-0000-000000000000}"/>
          </ac:grpSpMkLst>
        </pc:grpChg>
        <pc:grpChg chg="mod">
          <ac:chgData name="Connelly, Ashley N" userId="f98c3b42-ca58-4efb-bc7f-491d5980b7a9" providerId="ADAL" clId="{1DF4AF3F-6983-4E84-AF5B-817065518A35}" dt="2021-11-20T21:50:20.595" v="88"/>
          <ac:grpSpMkLst>
            <pc:docMk/>
            <pc:sldMk cId="3081025213" sldId="370"/>
            <ac:grpSpMk id="52" creationId="{00000000-0000-0000-0000-000000000000}"/>
          </ac:grpSpMkLst>
        </pc:grpChg>
        <pc:grpChg chg="mod">
          <ac:chgData name="Connelly, Ashley N" userId="f98c3b42-ca58-4efb-bc7f-491d5980b7a9" providerId="ADAL" clId="{1DF4AF3F-6983-4E84-AF5B-817065518A35}" dt="2021-11-20T21:55:43.875" v="105"/>
          <ac:grpSpMkLst>
            <pc:docMk/>
            <pc:sldMk cId="3081025213" sldId="370"/>
            <ac:grpSpMk id="59" creationId="{00000000-0000-0000-0000-000000000000}"/>
          </ac:grpSpMkLst>
        </pc:grpChg>
        <pc:graphicFrameChg chg="mod">
          <ac:chgData name="Connelly, Ashley N" userId="f98c3b42-ca58-4efb-bc7f-491d5980b7a9" providerId="ADAL" clId="{1DF4AF3F-6983-4E84-AF5B-817065518A35}" dt="2021-11-20T21:34:42.546" v="43"/>
          <ac:graphicFrameMkLst>
            <pc:docMk/>
            <pc:sldMk cId="3081025213" sldId="370"/>
            <ac:graphicFrameMk id="36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35:41.342" v="46"/>
          <ac:graphicFrameMkLst>
            <pc:docMk/>
            <pc:sldMk cId="3081025213" sldId="370"/>
            <ac:graphicFrameMk id="37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36:48.514" v="49"/>
          <ac:graphicFrameMkLst>
            <pc:docMk/>
            <pc:sldMk cId="3081025213" sldId="370"/>
            <ac:graphicFrameMk id="38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38:05.216" v="53"/>
          <ac:graphicFrameMkLst>
            <pc:docMk/>
            <pc:sldMk cId="3081025213" sldId="370"/>
            <ac:graphicFrameMk id="39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37:27.121" v="51"/>
          <ac:graphicFrameMkLst>
            <pc:docMk/>
            <pc:sldMk cId="3081025213" sldId="370"/>
            <ac:graphicFrameMk id="40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38:51.461" v="55"/>
          <ac:graphicFrameMkLst>
            <pc:docMk/>
            <pc:sldMk cId="3081025213" sldId="370"/>
            <ac:graphicFrameMk id="43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39:53.396" v="58"/>
          <ac:graphicFrameMkLst>
            <pc:docMk/>
            <pc:sldMk cId="3081025213" sldId="370"/>
            <ac:graphicFrameMk id="44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40:28.884" v="60"/>
          <ac:graphicFrameMkLst>
            <pc:docMk/>
            <pc:sldMk cId="3081025213" sldId="370"/>
            <ac:graphicFrameMk id="45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41:46.524" v="64"/>
          <ac:graphicFrameMkLst>
            <pc:docMk/>
            <pc:sldMk cId="3081025213" sldId="370"/>
            <ac:graphicFrameMk id="46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2-01T16:57:46.259" v="710"/>
          <ac:graphicFrameMkLst>
            <pc:docMk/>
            <pc:sldMk cId="3081025213" sldId="370"/>
            <ac:graphicFrameMk id="47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0:20.595" v="88"/>
          <ac:graphicFrameMkLst>
            <pc:docMk/>
            <pc:sldMk cId="3081025213" sldId="370"/>
            <ac:graphicFrameMk id="53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0:20.595" v="88"/>
          <ac:graphicFrameMkLst>
            <pc:docMk/>
            <pc:sldMk cId="3081025213" sldId="370"/>
            <ac:graphicFrameMk id="54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0:20.595" v="88"/>
          <ac:graphicFrameMkLst>
            <pc:docMk/>
            <pc:sldMk cId="3081025213" sldId="370"/>
            <ac:graphicFrameMk id="55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0:20.595" v="88"/>
          <ac:graphicFrameMkLst>
            <pc:docMk/>
            <pc:sldMk cId="3081025213" sldId="370"/>
            <ac:graphicFrameMk id="56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0:21.248" v="89"/>
          <ac:graphicFrameMkLst>
            <pc:docMk/>
            <pc:sldMk cId="3081025213" sldId="370"/>
            <ac:graphicFrameMk id="57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5:43.875" v="105"/>
          <ac:graphicFrameMkLst>
            <pc:docMk/>
            <pc:sldMk cId="3081025213" sldId="370"/>
            <ac:graphicFrameMk id="60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5:43.875" v="105"/>
          <ac:graphicFrameMkLst>
            <pc:docMk/>
            <pc:sldMk cId="3081025213" sldId="370"/>
            <ac:graphicFrameMk id="61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5:43.875" v="105"/>
          <ac:graphicFrameMkLst>
            <pc:docMk/>
            <pc:sldMk cId="3081025213" sldId="370"/>
            <ac:graphicFrameMk id="62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7:03.554" v="106"/>
          <ac:graphicFrameMkLst>
            <pc:docMk/>
            <pc:sldMk cId="3081025213" sldId="370"/>
            <ac:graphicFrameMk id="63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1-20T21:55:43.875" v="105"/>
          <ac:graphicFrameMkLst>
            <pc:docMk/>
            <pc:sldMk cId="3081025213" sldId="370"/>
            <ac:graphicFrameMk id="64" creationId="{00000000-0000-0000-0000-000000000000}"/>
          </ac:graphicFrameMkLst>
        </pc:graphicFrameChg>
      </pc:sldChg>
      <pc:sldChg chg="modSp mod">
        <pc:chgData name="Connelly, Ashley N" userId="f98c3b42-ca58-4efb-bc7f-491d5980b7a9" providerId="ADAL" clId="{1DF4AF3F-6983-4E84-AF5B-817065518A35}" dt="2021-12-01T17:20:10.317" v="727" actId="20577"/>
        <pc:sldMkLst>
          <pc:docMk/>
          <pc:sldMk cId="2467648676" sldId="402"/>
        </pc:sldMkLst>
        <pc:spChg chg="mod">
          <ac:chgData name="Connelly, Ashley N" userId="f98c3b42-ca58-4efb-bc7f-491d5980b7a9" providerId="ADAL" clId="{1DF4AF3F-6983-4E84-AF5B-817065518A35}" dt="2021-12-01T17:20:10.317" v="727" actId="20577"/>
          <ac:spMkLst>
            <pc:docMk/>
            <pc:sldMk cId="2467648676" sldId="402"/>
            <ac:spMk id="3" creationId="{00000000-0000-0000-0000-000000000000}"/>
          </ac:spMkLst>
        </pc:spChg>
      </pc:sldChg>
      <pc:sldChg chg="modSp mod">
        <pc:chgData name="Connelly, Ashley N" userId="f98c3b42-ca58-4efb-bc7f-491d5980b7a9" providerId="ADAL" clId="{1DF4AF3F-6983-4E84-AF5B-817065518A35}" dt="2021-12-01T17:20:00.492" v="725" actId="20577"/>
        <pc:sldMkLst>
          <pc:docMk/>
          <pc:sldMk cId="514368172" sldId="411"/>
        </pc:sldMkLst>
        <pc:spChg chg="mod">
          <ac:chgData name="Connelly, Ashley N" userId="f98c3b42-ca58-4efb-bc7f-491d5980b7a9" providerId="ADAL" clId="{1DF4AF3F-6983-4E84-AF5B-817065518A35}" dt="2021-12-01T17:20:00.492" v="725" actId="20577"/>
          <ac:spMkLst>
            <pc:docMk/>
            <pc:sldMk cId="514368172" sldId="411"/>
            <ac:spMk id="33" creationId="{00000000-0000-0000-0000-000000000000}"/>
          </ac:spMkLst>
        </pc:spChg>
      </pc:sldChg>
      <pc:sldChg chg="modSp mod">
        <pc:chgData name="Connelly, Ashley N" userId="f98c3b42-ca58-4efb-bc7f-491d5980b7a9" providerId="ADAL" clId="{1DF4AF3F-6983-4E84-AF5B-817065518A35}" dt="2021-12-01T17:20:14.914" v="728" actId="20577"/>
        <pc:sldMkLst>
          <pc:docMk/>
          <pc:sldMk cId="1540686869" sldId="413"/>
        </pc:sldMkLst>
        <pc:spChg chg="mod">
          <ac:chgData name="Connelly, Ashley N" userId="f98c3b42-ca58-4efb-bc7f-491d5980b7a9" providerId="ADAL" clId="{1DF4AF3F-6983-4E84-AF5B-817065518A35}" dt="2021-12-01T17:20:14.914" v="728" actId="20577"/>
          <ac:spMkLst>
            <pc:docMk/>
            <pc:sldMk cId="1540686869" sldId="413"/>
            <ac:spMk id="3" creationId="{00000000-0000-0000-0000-000000000000}"/>
          </ac:spMkLst>
        </pc:spChg>
      </pc:sldChg>
      <pc:sldChg chg="addSp modSp mod">
        <pc:chgData name="Connelly, Ashley N" userId="f98c3b42-ca58-4efb-bc7f-491d5980b7a9" providerId="ADAL" clId="{1DF4AF3F-6983-4E84-AF5B-817065518A35}" dt="2021-12-01T17:19:47.763" v="723" actId="20577"/>
        <pc:sldMkLst>
          <pc:docMk/>
          <pc:sldMk cId="1211876232" sldId="421"/>
        </pc:sldMkLst>
        <pc:spChg chg="mod">
          <ac:chgData name="Connelly, Ashley N" userId="f98c3b42-ca58-4efb-bc7f-491d5980b7a9" providerId="ADAL" clId="{1DF4AF3F-6983-4E84-AF5B-817065518A35}" dt="2021-12-01T17:19:47.763" v="723" actId="20577"/>
          <ac:spMkLst>
            <pc:docMk/>
            <pc:sldMk cId="1211876232" sldId="421"/>
            <ac:spMk id="8" creationId="{00000000-0000-0000-0000-000000000000}"/>
          </ac:spMkLst>
        </pc:spChg>
        <pc:spChg chg="add mod">
          <ac:chgData name="Connelly, Ashley N" userId="f98c3b42-ca58-4efb-bc7f-491d5980b7a9" providerId="ADAL" clId="{1DF4AF3F-6983-4E84-AF5B-817065518A35}" dt="2021-12-01T15:24:18.519" v="157" actId="20577"/>
          <ac:spMkLst>
            <pc:docMk/>
            <pc:sldMk cId="1211876232" sldId="421"/>
            <ac:spMk id="9" creationId="{40474D8B-1A40-488C-ADF5-C0397638267F}"/>
          </ac:spMkLst>
        </pc:spChg>
        <pc:spChg chg="add mod">
          <ac:chgData name="Connelly, Ashley N" userId="f98c3b42-ca58-4efb-bc7f-491d5980b7a9" providerId="ADAL" clId="{1DF4AF3F-6983-4E84-AF5B-817065518A35}" dt="2021-12-01T15:55:02.799" v="428" actId="164"/>
          <ac:spMkLst>
            <pc:docMk/>
            <pc:sldMk cId="1211876232" sldId="421"/>
            <ac:spMk id="12" creationId="{8E1A6523-EC9E-4DC7-AC76-D4B49133F636}"/>
          </ac:spMkLst>
        </pc:spChg>
        <pc:spChg chg="add mod">
          <ac:chgData name="Connelly, Ashley N" userId="f98c3b42-ca58-4efb-bc7f-491d5980b7a9" providerId="ADAL" clId="{1DF4AF3F-6983-4E84-AF5B-817065518A35}" dt="2021-12-01T15:54:48.668" v="410" actId="164"/>
          <ac:spMkLst>
            <pc:docMk/>
            <pc:sldMk cId="1211876232" sldId="421"/>
            <ac:spMk id="15" creationId="{653E0916-93F6-48F4-A2A5-42521A9B17BD}"/>
          </ac:spMkLst>
        </pc:spChg>
        <pc:spChg chg="add mod">
          <ac:chgData name="Connelly, Ashley N" userId="f98c3b42-ca58-4efb-bc7f-491d5980b7a9" providerId="ADAL" clId="{1DF4AF3F-6983-4E84-AF5B-817065518A35}" dt="2021-12-01T15:56:14.775" v="478" actId="122"/>
          <ac:spMkLst>
            <pc:docMk/>
            <pc:sldMk cId="1211876232" sldId="421"/>
            <ac:spMk id="21" creationId="{E9786AFB-D95A-46DE-A4C8-F6ED7F90BB42}"/>
          </ac:spMkLst>
        </pc:spChg>
        <pc:spChg chg="add mod">
          <ac:chgData name="Connelly, Ashley N" userId="f98c3b42-ca58-4efb-bc7f-491d5980b7a9" providerId="ADAL" clId="{1DF4AF3F-6983-4E84-AF5B-817065518A35}" dt="2021-12-01T15:57:55.718" v="520" actId="208"/>
          <ac:spMkLst>
            <pc:docMk/>
            <pc:sldMk cId="1211876232" sldId="421"/>
            <ac:spMk id="22" creationId="{296FCC84-B6AE-4C72-ABA5-F18A7587686B}"/>
          </ac:spMkLst>
        </pc:spChg>
        <pc:spChg chg="add mod">
          <ac:chgData name="Connelly, Ashley N" userId="f98c3b42-ca58-4efb-bc7f-491d5980b7a9" providerId="ADAL" clId="{1DF4AF3F-6983-4E84-AF5B-817065518A35}" dt="2021-12-01T15:57:39.070" v="519" actId="1076"/>
          <ac:spMkLst>
            <pc:docMk/>
            <pc:sldMk cId="1211876232" sldId="421"/>
            <ac:spMk id="24" creationId="{84C3E1AA-4FB8-4155-B296-5C32A2E59E20}"/>
          </ac:spMkLst>
        </pc:spChg>
        <pc:grpChg chg="add mod">
          <ac:chgData name="Connelly, Ashley N" userId="f98c3b42-ca58-4efb-bc7f-491d5980b7a9" providerId="ADAL" clId="{1DF4AF3F-6983-4E84-AF5B-817065518A35}" dt="2021-12-01T15:55:21.795" v="452" actId="1037"/>
          <ac:grpSpMkLst>
            <pc:docMk/>
            <pc:sldMk cId="1211876232" sldId="421"/>
            <ac:grpSpMk id="16" creationId="{9E323399-D153-4259-9843-438E5511A002}"/>
          </ac:grpSpMkLst>
        </pc:grpChg>
        <pc:grpChg chg="add mod">
          <ac:chgData name="Connelly, Ashley N" userId="f98c3b42-ca58-4efb-bc7f-491d5980b7a9" providerId="ADAL" clId="{1DF4AF3F-6983-4E84-AF5B-817065518A35}" dt="2021-12-01T15:55:02.799" v="428" actId="164"/>
          <ac:grpSpMkLst>
            <pc:docMk/>
            <pc:sldMk cId="1211876232" sldId="421"/>
            <ac:grpSpMk id="17" creationId="{9BDC6459-AAA9-475E-94E8-9EDA8F678F7C}"/>
          </ac:grpSpMkLst>
        </pc:grpChg>
        <pc:graphicFrameChg chg="mod">
          <ac:chgData name="Connelly, Ashley N" userId="f98c3b42-ca58-4efb-bc7f-491d5980b7a9" providerId="ADAL" clId="{1DF4AF3F-6983-4E84-AF5B-817065518A35}" dt="2021-12-01T15:24:13.615" v="155" actId="1036"/>
          <ac:graphicFrameMkLst>
            <pc:docMk/>
            <pc:sldMk cId="1211876232" sldId="421"/>
            <ac:graphicFrameMk id="2" creationId="{00000000-0000-0000-0000-000000000000}"/>
          </ac:graphicFrameMkLst>
        </pc:graphicFrameChg>
        <pc:graphicFrameChg chg="mod">
          <ac:chgData name="Connelly, Ashley N" userId="f98c3b42-ca58-4efb-bc7f-491d5980b7a9" providerId="ADAL" clId="{1DF4AF3F-6983-4E84-AF5B-817065518A35}" dt="2021-12-01T15:24:13.615" v="155" actId="1036"/>
          <ac:graphicFrameMkLst>
            <pc:docMk/>
            <pc:sldMk cId="1211876232" sldId="421"/>
            <ac:graphicFrameMk id="4" creationId="{00000000-0000-0000-0000-000000000000}"/>
          </ac:graphicFrameMkLst>
        </pc:graphicFrameChg>
        <pc:picChg chg="add mod">
          <ac:chgData name="Connelly, Ashley N" userId="f98c3b42-ca58-4efb-bc7f-491d5980b7a9" providerId="ADAL" clId="{1DF4AF3F-6983-4E84-AF5B-817065518A35}" dt="2021-12-01T15:55:02.799" v="428" actId="164"/>
          <ac:picMkLst>
            <pc:docMk/>
            <pc:sldMk cId="1211876232" sldId="421"/>
            <ac:picMk id="5" creationId="{E3925FA2-BB10-46B7-9479-F797D24196A6}"/>
          </ac:picMkLst>
        </pc:picChg>
        <pc:picChg chg="add mod">
          <ac:chgData name="Connelly, Ashley N" userId="f98c3b42-ca58-4efb-bc7f-491d5980b7a9" providerId="ADAL" clId="{1DF4AF3F-6983-4E84-AF5B-817065518A35}" dt="2021-12-01T15:54:48.668" v="410" actId="164"/>
          <ac:picMkLst>
            <pc:docMk/>
            <pc:sldMk cId="1211876232" sldId="421"/>
            <ac:picMk id="11" creationId="{37648C0B-ACB3-45AB-B06F-C2AE216A757F}"/>
          </ac:picMkLst>
        </pc:picChg>
        <pc:cxnChg chg="add mod">
          <ac:chgData name="Connelly, Ashley N" userId="f98c3b42-ca58-4efb-bc7f-491d5980b7a9" providerId="ADAL" clId="{1DF4AF3F-6983-4E84-AF5B-817065518A35}" dt="2021-12-01T15:55:16.475" v="448" actId="14100"/>
          <ac:cxnSpMkLst>
            <pc:docMk/>
            <pc:sldMk cId="1211876232" sldId="421"/>
            <ac:cxnSpMk id="14" creationId="{4C55EB4D-530B-473A-A1E2-6AE37ED6658F}"/>
          </ac:cxnSpMkLst>
        </pc:cxnChg>
        <pc:cxnChg chg="add mod">
          <ac:chgData name="Connelly, Ashley N" userId="f98c3b42-ca58-4efb-bc7f-491d5980b7a9" providerId="ADAL" clId="{1DF4AF3F-6983-4E84-AF5B-817065518A35}" dt="2021-12-01T15:55:37.990" v="455" actId="208"/>
          <ac:cxnSpMkLst>
            <pc:docMk/>
            <pc:sldMk cId="1211876232" sldId="421"/>
            <ac:cxnSpMk id="20" creationId="{61FC44AD-49A0-4A23-A8B1-E1A5BD6EA805}"/>
          </ac:cxnSpMkLst>
        </pc:cxnChg>
      </pc:sldChg>
      <pc:sldChg chg="modSp mod">
        <pc:chgData name="Connelly, Ashley N" userId="f98c3b42-ca58-4efb-bc7f-491d5980b7a9" providerId="ADAL" clId="{1DF4AF3F-6983-4E84-AF5B-817065518A35}" dt="2021-12-01T17:19:54.361" v="724" actId="20577"/>
        <pc:sldMkLst>
          <pc:docMk/>
          <pc:sldMk cId="2320163995" sldId="436"/>
        </pc:sldMkLst>
        <pc:spChg chg="mod">
          <ac:chgData name="Connelly, Ashley N" userId="f98c3b42-ca58-4efb-bc7f-491d5980b7a9" providerId="ADAL" clId="{1DF4AF3F-6983-4E84-AF5B-817065518A35}" dt="2021-12-01T17:19:54.361" v="724" actId="20577"/>
          <ac:spMkLst>
            <pc:docMk/>
            <pc:sldMk cId="2320163995" sldId="436"/>
            <ac:spMk id="69" creationId="{00000000-0000-0000-0000-000000000000}"/>
          </ac:spMkLst>
        </pc:spChg>
      </pc:sldChg>
      <pc:sldChg chg="modSp mod">
        <pc:chgData name="Connelly, Ashley N" userId="f98c3b42-ca58-4efb-bc7f-491d5980b7a9" providerId="ADAL" clId="{1DF4AF3F-6983-4E84-AF5B-817065518A35}" dt="2021-12-01T17:19:37.846" v="722" actId="20577"/>
        <pc:sldMkLst>
          <pc:docMk/>
          <pc:sldMk cId="2533612953" sldId="437"/>
        </pc:sldMkLst>
        <pc:spChg chg="mod">
          <ac:chgData name="Connelly, Ashley N" userId="f98c3b42-ca58-4efb-bc7f-491d5980b7a9" providerId="ADAL" clId="{1DF4AF3F-6983-4E84-AF5B-817065518A35}" dt="2021-12-01T17:19:37.846" v="722" actId="20577"/>
          <ac:spMkLst>
            <pc:docMk/>
            <pc:sldMk cId="2533612953" sldId="437"/>
            <ac:spMk id="3" creationId="{00000000-0000-0000-0000-000000000000}"/>
          </ac:spMkLst>
        </pc:spChg>
      </pc:sldChg>
      <pc:sldChg chg="addSp modSp new mod ord">
        <pc:chgData name="Connelly, Ashley N" userId="f98c3b42-ca58-4efb-bc7f-491d5980b7a9" providerId="ADAL" clId="{1DF4AF3F-6983-4E84-AF5B-817065518A35}" dt="2021-12-01T16:58:29.438" v="716" actId="1076"/>
        <pc:sldMkLst>
          <pc:docMk/>
          <pc:sldMk cId="4066428149" sldId="438"/>
        </pc:sldMkLst>
        <pc:spChg chg="add mod">
          <ac:chgData name="Connelly, Ashley N" userId="f98c3b42-ca58-4efb-bc7f-491d5980b7a9" providerId="ADAL" clId="{1DF4AF3F-6983-4E84-AF5B-817065518A35}" dt="2021-12-01T16:58:29.438" v="716" actId="1076"/>
          <ac:spMkLst>
            <pc:docMk/>
            <pc:sldMk cId="4066428149" sldId="438"/>
            <ac:spMk id="3" creationId="{9C5206B1-8A6E-4244-A045-5F59FEC2E76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6912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7AF39B4E-4463-4671-83D3-2C39687A77F3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2038" y="1163638"/>
            <a:ext cx="2355850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78476"/>
            <a:ext cx="5615940" cy="3664208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6911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5EC077BA-E126-4BCF-8BF1-2D5E874EE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4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2038" y="1163638"/>
            <a:ext cx="2355850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 defTabSz="932871">
              <a:buFont typeface="Arial" panose="020B0604020202020204" pitchFamily="34" charset="0"/>
              <a:buNone/>
              <a:defRPr/>
            </a:pP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C077BA-E126-4BCF-8BF1-2D5E874EE43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5128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2038" y="1163638"/>
            <a:ext cx="2355850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2871">
              <a:defRPr/>
            </a:pPr>
            <a:r>
              <a:rPr lang="en-US" dirty="0"/>
              <a:t>Fig. 2</a:t>
            </a:r>
          </a:p>
          <a:p>
            <a:pPr defTabSz="932871">
              <a:defRPr/>
            </a:pPr>
            <a:r>
              <a:rPr lang="en-US" dirty="0"/>
              <a:t>Overlays are CTP-011</a:t>
            </a:r>
          </a:p>
          <a:p>
            <a:pPr defTabSz="932871">
              <a:defRPr/>
            </a:pPr>
            <a:endParaRPr lang="en-US" baseline="0" dirty="0"/>
          </a:p>
          <a:p>
            <a:pPr defTabSz="932871"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C077BA-E126-4BCF-8BF1-2D5E874EE43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7235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2038" y="1163638"/>
            <a:ext cx="2355850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33218" indent="-233218">
              <a:buAutoNum type="alphaLcPeriod"/>
            </a:pPr>
            <a:r>
              <a:rPr lang="en-US" baseline="0" dirty="0"/>
              <a:t> </a:t>
            </a:r>
          </a:p>
          <a:p>
            <a:pPr marL="233218" indent="-233218">
              <a:buAutoNum type="alphaLcPeriod"/>
            </a:pPr>
            <a:r>
              <a:rPr lang="en-US" baseline="0" dirty="0"/>
              <a:t> </a:t>
            </a:r>
          </a:p>
          <a:p>
            <a:pPr marL="233218" indent="-233218">
              <a:buAutoNum type="alphaLcPeriod"/>
            </a:pPr>
            <a:r>
              <a:rPr lang="en-US" baseline="0" dirty="0"/>
              <a:t>Non specific markers for ACD</a:t>
            </a:r>
          </a:p>
          <a:p>
            <a:pPr marL="233218" indent="-233218">
              <a:buAutoNum type="alphaLcPeriod"/>
            </a:pPr>
            <a:r>
              <a:rPr lang="en-US" baseline="0" dirty="0"/>
              <a:t>Specific markers for EDTA (</a:t>
            </a:r>
            <a:r>
              <a:rPr lang="en-US" baseline="0" dirty="0" err="1"/>
              <a:t>MannWhit</a:t>
            </a:r>
            <a:r>
              <a:rPr lang="en-US" baseline="0" dirty="0"/>
              <a:t>)</a:t>
            </a:r>
          </a:p>
          <a:p>
            <a:pPr marL="233218" indent="-233218">
              <a:buAutoNum type="alphaLcPeriod"/>
            </a:pPr>
            <a:r>
              <a:rPr lang="en-US" baseline="0" dirty="0"/>
              <a:t>Non Specific EDTA(</a:t>
            </a:r>
            <a:r>
              <a:rPr lang="en-US" baseline="0" dirty="0" err="1"/>
              <a:t>MannWhit</a:t>
            </a:r>
            <a:r>
              <a:rPr lang="en-US" baseline="0" dirty="0"/>
              <a:t>)</a:t>
            </a:r>
          </a:p>
          <a:p>
            <a:pPr marL="233218" indent="-233218">
              <a:buAutoNum type="alphaLcPeriod"/>
            </a:pPr>
            <a:r>
              <a:rPr lang="en-US" baseline="0" dirty="0"/>
              <a:t>Specific markers and %CD177+ for Heparin (</a:t>
            </a:r>
            <a:r>
              <a:rPr lang="en-US" baseline="0" dirty="0" err="1"/>
              <a:t>MannWhit</a:t>
            </a:r>
            <a:r>
              <a:rPr lang="en-US" baseline="0" dirty="0"/>
              <a:t>)</a:t>
            </a:r>
          </a:p>
          <a:p>
            <a:pPr marL="233218" indent="-233218">
              <a:buAutoNum type="alphaLcPeriod"/>
            </a:pPr>
            <a:r>
              <a:rPr lang="en-US" baseline="0" dirty="0" err="1"/>
              <a:t>NonSpecific</a:t>
            </a:r>
            <a:r>
              <a:rPr lang="en-US" baseline="0" dirty="0"/>
              <a:t> markers for </a:t>
            </a:r>
            <a:r>
              <a:rPr lang="en-US" baseline="0" dirty="0" err="1"/>
              <a:t>Hep</a:t>
            </a:r>
            <a:r>
              <a:rPr lang="en-US" baseline="0" dirty="0"/>
              <a:t> (</a:t>
            </a:r>
            <a:r>
              <a:rPr lang="en-US" baseline="0" dirty="0" err="1"/>
              <a:t>MannWhit</a:t>
            </a:r>
            <a:r>
              <a:rPr lang="en-US" baseline="0" dirty="0"/>
              <a:t>)</a:t>
            </a:r>
          </a:p>
          <a:p>
            <a:pPr marL="233218" indent="-233218">
              <a:buAutoNum type="alphaLcPeriod"/>
            </a:pP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C077BA-E126-4BCF-8BF1-2D5E874EE43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0062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2038" y="1163638"/>
            <a:ext cx="2355850" cy="3140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.</a:t>
            </a:r>
            <a:r>
              <a:rPr lang="en-US" baseline="0" dirty="0"/>
              <a:t> 2 Time to stain Comparison</a:t>
            </a:r>
          </a:p>
          <a:p>
            <a:pPr marL="233218" indent="-233218">
              <a:buAutoNum type="alphaUcPeriod"/>
            </a:pPr>
            <a:r>
              <a:rPr lang="en-US" baseline="0" dirty="0"/>
              <a:t>Remaining ACD WB and PMN markers</a:t>
            </a:r>
          </a:p>
          <a:p>
            <a:pPr marL="233218" indent="-233218">
              <a:buAutoNum type="alphaUcPeriod"/>
            </a:pPr>
            <a:r>
              <a:rPr lang="en-US" baseline="0" dirty="0"/>
              <a:t>ACD nonspecific markers WB</a:t>
            </a:r>
          </a:p>
          <a:p>
            <a:pPr marL="233218" indent="-233218">
              <a:buAutoNum type="alphaUcPeriod"/>
            </a:pPr>
            <a:r>
              <a:rPr lang="en-US" baseline="0" dirty="0"/>
              <a:t>ACD nonspecific markers PMNs</a:t>
            </a:r>
          </a:p>
          <a:p>
            <a:pPr marL="233218" indent="-233218">
              <a:buAutoNum type="alphaUcPeriod"/>
            </a:pPr>
            <a:endParaRPr lang="en-US" baseline="0" dirty="0"/>
          </a:p>
          <a:p>
            <a:pPr marL="233218" indent="-233218">
              <a:buAutoNum type="alphaUcPeriod"/>
            </a:pP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C077BA-E126-4BCF-8BF1-2D5E874EE43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7081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C077BA-E126-4BCF-8BF1-2D5E874EE43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5497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314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865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411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393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922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927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664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456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370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333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195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BD291-FA28-450A-869A-6611A5C75238}" type="datetimeFigureOut">
              <a:rPr lang="en-US" smtClean="0"/>
              <a:t>11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BF23B-BAE1-4ABD-AF78-0D183684C2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578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image" Target="../media/image5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oleObject" Target="../embeddings/oleObject10.bin"/><Relationship Id="rId18" Type="http://schemas.openxmlformats.org/officeDocument/2006/relationships/image" Target="../media/image14.emf"/><Relationship Id="rId3" Type="http://schemas.openxmlformats.org/officeDocument/2006/relationships/oleObject" Target="../embeddings/oleObject5.bin"/><Relationship Id="rId21" Type="http://schemas.openxmlformats.org/officeDocument/2006/relationships/oleObject" Target="../embeddings/oleObject14.bin"/><Relationship Id="rId7" Type="http://schemas.openxmlformats.org/officeDocument/2006/relationships/oleObject" Target="../embeddings/oleObject7.bin"/><Relationship Id="rId12" Type="http://schemas.openxmlformats.org/officeDocument/2006/relationships/image" Target="../media/image11.emf"/><Relationship Id="rId17" Type="http://schemas.openxmlformats.org/officeDocument/2006/relationships/oleObject" Target="../embeddings/oleObject12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3.emf"/><Relationship Id="rId20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11" Type="http://schemas.openxmlformats.org/officeDocument/2006/relationships/oleObject" Target="../embeddings/oleObject9.bin"/><Relationship Id="rId5" Type="http://schemas.openxmlformats.org/officeDocument/2006/relationships/oleObject" Target="../embeddings/oleObject6.bin"/><Relationship Id="rId15" Type="http://schemas.openxmlformats.org/officeDocument/2006/relationships/oleObject" Target="../embeddings/oleObject11.bin"/><Relationship Id="rId10" Type="http://schemas.openxmlformats.org/officeDocument/2006/relationships/image" Target="../media/image10.emf"/><Relationship Id="rId19" Type="http://schemas.openxmlformats.org/officeDocument/2006/relationships/oleObject" Target="../embeddings/oleObject13.bin"/><Relationship Id="rId4" Type="http://schemas.openxmlformats.org/officeDocument/2006/relationships/image" Target="../media/image7.emf"/><Relationship Id="rId9" Type="http://schemas.openxmlformats.org/officeDocument/2006/relationships/oleObject" Target="../embeddings/oleObject8.bin"/><Relationship Id="rId14" Type="http://schemas.openxmlformats.org/officeDocument/2006/relationships/image" Target="../media/image12.emf"/><Relationship Id="rId22" Type="http://schemas.openxmlformats.org/officeDocument/2006/relationships/image" Target="../media/image16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oleObject" Target="../embeddings/oleObject20.bin"/><Relationship Id="rId18" Type="http://schemas.openxmlformats.org/officeDocument/2006/relationships/image" Target="../media/image24.emf"/><Relationship Id="rId3" Type="http://schemas.openxmlformats.org/officeDocument/2006/relationships/oleObject" Target="../embeddings/oleObject15.bin"/><Relationship Id="rId21" Type="http://schemas.openxmlformats.org/officeDocument/2006/relationships/oleObject" Target="../embeddings/oleObject24.bin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21.emf"/><Relationship Id="rId17" Type="http://schemas.openxmlformats.org/officeDocument/2006/relationships/oleObject" Target="../embeddings/oleObject22.bin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3.emf"/><Relationship Id="rId20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emf"/><Relationship Id="rId11" Type="http://schemas.openxmlformats.org/officeDocument/2006/relationships/oleObject" Target="../embeddings/oleObject19.bin"/><Relationship Id="rId5" Type="http://schemas.openxmlformats.org/officeDocument/2006/relationships/oleObject" Target="../embeddings/oleObject16.bin"/><Relationship Id="rId15" Type="http://schemas.openxmlformats.org/officeDocument/2006/relationships/oleObject" Target="../embeddings/oleObject21.bin"/><Relationship Id="rId10" Type="http://schemas.openxmlformats.org/officeDocument/2006/relationships/image" Target="../media/image20.emf"/><Relationship Id="rId19" Type="http://schemas.openxmlformats.org/officeDocument/2006/relationships/oleObject" Target="../embeddings/oleObject23.bin"/><Relationship Id="rId4" Type="http://schemas.openxmlformats.org/officeDocument/2006/relationships/image" Target="../media/image17.emf"/><Relationship Id="rId9" Type="http://schemas.openxmlformats.org/officeDocument/2006/relationships/oleObject" Target="../embeddings/oleObject18.bin"/><Relationship Id="rId14" Type="http://schemas.openxmlformats.org/officeDocument/2006/relationships/image" Target="../media/image22.emf"/><Relationship Id="rId22" Type="http://schemas.openxmlformats.org/officeDocument/2006/relationships/image" Target="../media/image26.emf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30.bin"/><Relationship Id="rId18" Type="http://schemas.openxmlformats.org/officeDocument/2006/relationships/image" Target="../media/image34.emf"/><Relationship Id="rId26" Type="http://schemas.openxmlformats.org/officeDocument/2006/relationships/image" Target="../media/image38.emf"/><Relationship Id="rId39" Type="http://schemas.openxmlformats.org/officeDocument/2006/relationships/oleObject" Target="../embeddings/oleObject43.bin"/><Relationship Id="rId21" Type="http://schemas.openxmlformats.org/officeDocument/2006/relationships/oleObject" Target="../embeddings/oleObject34.bin"/><Relationship Id="rId34" Type="http://schemas.openxmlformats.org/officeDocument/2006/relationships/image" Target="../media/image42.emf"/><Relationship Id="rId42" Type="http://schemas.openxmlformats.org/officeDocument/2006/relationships/image" Target="../media/image46.emf"/><Relationship Id="rId7" Type="http://schemas.openxmlformats.org/officeDocument/2006/relationships/oleObject" Target="../embeddings/oleObject27.bin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33.emf"/><Relationship Id="rId20" Type="http://schemas.openxmlformats.org/officeDocument/2006/relationships/image" Target="../media/image35.emf"/><Relationship Id="rId29" Type="http://schemas.openxmlformats.org/officeDocument/2006/relationships/oleObject" Target="../embeddings/oleObject38.bin"/><Relationship Id="rId41" Type="http://schemas.openxmlformats.org/officeDocument/2006/relationships/oleObject" Target="../embeddings/oleObject44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11" Type="http://schemas.openxmlformats.org/officeDocument/2006/relationships/oleObject" Target="../embeddings/oleObject29.bin"/><Relationship Id="rId24" Type="http://schemas.openxmlformats.org/officeDocument/2006/relationships/image" Target="../media/image37.emf"/><Relationship Id="rId32" Type="http://schemas.openxmlformats.org/officeDocument/2006/relationships/image" Target="../media/image41.emf"/><Relationship Id="rId37" Type="http://schemas.openxmlformats.org/officeDocument/2006/relationships/oleObject" Target="../embeddings/oleObject42.bin"/><Relationship Id="rId40" Type="http://schemas.openxmlformats.org/officeDocument/2006/relationships/image" Target="../media/image45.emf"/><Relationship Id="rId5" Type="http://schemas.openxmlformats.org/officeDocument/2006/relationships/oleObject" Target="../embeddings/oleObject26.bin"/><Relationship Id="rId15" Type="http://schemas.openxmlformats.org/officeDocument/2006/relationships/oleObject" Target="../embeddings/oleObject31.bin"/><Relationship Id="rId23" Type="http://schemas.openxmlformats.org/officeDocument/2006/relationships/oleObject" Target="../embeddings/oleObject35.bin"/><Relationship Id="rId28" Type="http://schemas.openxmlformats.org/officeDocument/2006/relationships/image" Target="../media/image39.emf"/><Relationship Id="rId36" Type="http://schemas.openxmlformats.org/officeDocument/2006/relationships/image" Target="../media/image43.emf"/><Relationship Id="rId10" Type="http://schemas.openxmlformats.org/officeDocument/2006/relationships/image" Target="../media/image30.emf"/><Relationship Id="rId19" Type="http://schemas.openxmlformats.org/officeDocument/2006/relationships/oleObject" Target="../embeddings/oleObject33.bin"/><Relationship Id="rId31" Type="http://schemas.openxmlformats.org/officeDocument/2006/relationships/oleObject" Target="../embeddings/oleObject39.bin"/><Relationship Id="rId4" Type="http://schemas.openxmlformats.org/officeDocument/2006/relationships/image" Target="../media/image27.emf"/><Relationship Id="rId9" Type="http://schemas.openxmlformats.org/officeDocument/2006/relationships/oleObject" Target="../embeddings/oleObject28.bin"/><Relationship Id="rId14" Type="http://schemas.openxmlformats.org/officeDocument/2006/relationships/image" Target="../media/image32.emf"/><Relationship Id="rId22" Type="http://schemas.openxmlformats.org/officeDocument/2006/relationships/image" Target="../media/image36.emf"/><Relationship Id="rId27" Type="http://schemas.openxmlformats.org/officeDocument/2006/relationships/oleObject" Target="../embeddings/oleObject37.bin"/><Relationship Id="rId30" Type="http://schemas.openxmlformats.org/officeDocument/2006/relationships/image" Target="../media/image40.emf"/><Relationship Id="rId35" Type="http://schemas.openxmlformats.org/officeDocument/2006/relationships/oleObject" Target="../embeddings/oleObject41.bin"/><Relationship Id="rId8" Type="http://schemas.openxmlformats.org/officeDocument/2006/relationships/image" Target="../media/image29.emf"/><Relationship Id="rId3" Type="http://schemas.openxmlformats.org/officeDocument/2006/relationships/oleObject" Target="../embeddings/oleObject25.bin"/><Relationship Id="rId12" Type="http://schemas.openxmlformats.org/officeDocument/2006/relationships/image" Target="../media/image31.emf"/><Relationship Id="rId17" Type="http://schemas.openxmlformats.org/officeDocument/2006/relationships/oleObject" Target="../embeddings/oleObject32.bin"/><Relationship Id="rId25" Type="http://schemas.openxmlformats.org/officeDocument/2006/relationships/oleObject" Target="../embeddings/oleObject36.bin"/><Relationship Id="rId33" Type="http://schemas.openxmlformats.org/officeDocument/2006/relationships/oleObject" Target="../embeddings/oleObject40.bin"/><Relationship Id="rId38" Type="http://schemas.openxmlformats.org/officeDocument/2006/relationships/image" Target="../media/image44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C5206B1-8A6E-4244-A045-5F59FEC2E768}"/>
              </a:ext>
            </a:extLst>
          </p:cNvPr>
          <p:cNvSpPr txBox="1"/>
          <p:nvPr/>
        </p:nvSpPr>
        <p:spPr>
          <a:xfrm>
            <a:off x="0" y="790313"/>
            <a:ext cx="6858000" cy="22654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ptimization of methods for the accurate characterization of whole blood neutrophils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UTHORS: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hley N. Connelly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ichard P.H. Huijbregts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Harish C. Pal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Valeriya Kuznetsova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arcus D. Davis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Krystle L. Ong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hristian X. Fay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organ E. Greene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Edgar T. Overton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,4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Zdenek Hel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,3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64281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" y="203200"/>
            <a:ext cx="6451600" cy="85715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1: Cell recovery and neutrophil activation by method. (a)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eutrophil surface levels of indicated proteins following characterization by methods M1 – M10 as defined in Figure 1 and the Methods section.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b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Strategy for the identification of neutrophil multiplets. Neutrophils were identified as CD15+ and single cells were gated based on FSC-A and FSC-H. Multiplets were identified as ‘not’ single cells. (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)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 cell and monocyte recovery per microliter of original whole blood by the indicated method. Methods were analyzed using Mann-Whitney tests #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5, ##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1 when compared to M1 while *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5, ** 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1 compared to M2, n = 5. All samples were collected in ACD tubes and stained at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ºC.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2: Effect of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C lysis and fixation in the presence of antibodies on nonspecific antibody binding to monocytes and lymphocytes. (a/b)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onspecific antibody binding to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nocytes or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ymphocytes (T and B cells collectively). Bars indicate medians *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5, **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&lt; 0.01 by Mann-Whitney test.</a:t>
            </a: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3: Staining temperature trends hold in EDTA and heparin tubes. (a/b)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eutrophil surface protein levels following staining of whole blood collected in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DTA or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b)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eparin tubes at the indicated temperature. Bars indicate median.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endParaRPr lang="en-US" sz="10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4: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effects of anticoagulant type and sample processing delays on neutrophil phenotype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rface levels of the indicated proteins on neutrophils over time from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B collected in EDTA tubes,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PMN layer of a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coll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radient (EDTA tubes),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c)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B collected in heparin tubes, or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d)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PMN layer of a </a:t>
            </a:r>
            <a:r>
              <a:rPr lang="en-US" sz="1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coll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radient (heparin tubes). Results were compared using Friedman tests with Dunn’s multiple comparison post-hoc tests *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5, **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1, ***</a:t>
            </a:r>
            <a:r>
              <a:rPr lang="en-US" sz="10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&lt; 0.001. Samples were incubated at RT and stained at 4ºC.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S1: Antibodies.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omprehensive list of antibodies used in this study. 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S2: Reagents.</a:t>
            </a: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ist of reagents used in this study.</a:t>
            </a:r>
            <a:endParaRPr lang="en-US" sz="105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endParaRPr lang="en-US" sz="105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3612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218666" y="247971"/>
            <a:ext cx="424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218666" y="2057803"/>
            <a:ext cx="424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4800" y="8254425"/>
            <a:ext cx="624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: Cell recovery and neutrophil activation by method.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9573107"/>
              </p:ext>
            </p:extLst>
          </p:nvPr>
        </p:nvGraphicFramePr>
        <p:xfrm>
          <a:off x="429037" y="3910694"/>
          <a:ext cx="3122064" cy="1407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3" imgW="7095600" imgH="3198960" progId="Prism5.Document">
                  <p:embed/>
                </p:oleObj>
              </mc:Choice>
              <mc:Fallback>
                <p:oleObj name="Prism 5" r:id="rId3" imgW="7095600" imgH="3198960" progId="Prism5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9037" y="3910694"/>
                        <a:ext cx="3122064" cy="1407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5774798"/>
              </p:ext>
            </p:extLst>
          </p:nvPr>
        </p:nvGraphicFramePr>
        <p:xfrm>
          <a:off x="3768355" y="3719663"/>
          <a:ext cx="3073910" cy="15985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5" imgW="6986160" imgH="3633120" progId="Prism5.Document">
                  <p:embed/>
                </p:oleObj>
              </mc:Choice>
              <mc:Fallback>
                <p:oleObj name="Prism 5" r:id="rId5" imgW="6986160" imgH="363312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68355" y="3719663"/>
                        <a:ext cx="3073910" cy="15985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4163792"/>
              </p:ext>
            </p:extLst>
          </p:nvPr>
        </p:nvGraphicFramePr>
        <p:xfrm>
          <a:off x="413124" y="394717"/>
          <a:ext cx="3138221" cy="1494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7" imgW="7132320" imgH="3396960" progId="Prism5.Document">
                  <p:embed/>
                </p:oleObj>
              </mc:Choice>
              <mc:Fallback>
                <p:oleObj name="Prism 5" r:id="rId7" imgW="7132320" imgH="3396960" progId="Prism5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3124" y="394717"/>
                        <a:ext cx="3138221" cy="1494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9527806"/>
              </p:ext>
            </p:extLst>
          </p:nvPr>
        </p:nvGraphicFramePr>
        <p:xfrm>
          <a:off x="3697105" y="350523"/>
          <a:ext cx="3138221" cy="1538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9" imgW="7132320" imgH="3497400" progId="Prism5.Document">
                  <p:embed/>
                </p:oleObj>
              </mc:Choice>
              <mc:Fallback>
                <p:oleObj name="Prism 5" r:id="rId9" imgW="7132320" imgH="3497400" progId="Prism5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97105" y="350523"/>
                        <a:ext cx="3138221" cy="1538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40474D8B-1A40-488C-ADF5-C0397638267F}"/>
              </a:ext>
            </a:extLst>
          </p:cNvPr>
          <p:cNvSpPr txBox="1"/>
          <p:nvPr/>
        </p:nvSpPr>
        <p:spPr>
          <a:xfrm>
            <a:off x="218666" y="3787543"/>
            <a:ext cx="424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BDC6459-AAA9-475E-94E8-9EDA8F678F7C}"/>
              </a:ext>
            </a:extLst>
          </p:cNvPr>
          <p:cNvGrpSpPr/>
          <p:nvPr/>
        </p:nvGrpSpPr>
        <p:grpSpPr>
          <a:xfrm>
            <a:off x="429037" y="1977711"/>
            <a:ext cx="1685925" cy="1628775"/>
            <a:chOff x="429037" y="1977711"/>
            <a:chExt cx="1685925" cy="162877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3925FA2-BB10-46B7-9479-F797D24196A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29037" y="1977711"/>
              <a:ext cx="1685925" cy="1628775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E1A6523-EC9E-4DC7-AC76-D4B49133F636}"/>
                </a:ext>
              </a:extLst>
            </p:cNvPr>
            <p:cNvSpPr txBox="1"/>
            <p:nvPr/>
          </p:nvSpPr>
          <p:spPr>
            <a:xfrm>
              <a:off x="1074420" y="2112780"/>
              <a:ext cx="86868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5+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6%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E323399-D153-4259-9843-438E5511A002}"/>
              </a:ext>
            </a:extLst>
          </p:cNvPr>
          <p:cNvGrpSpPr/>
          <p:nvPr/>
        </p:nvGrpSpPr>
        <p:grpSpPr>
          <a:xfrm>
            <a:off x="3110865" y="1977710"/>
            <a:ext cx="1743074" cy="1628775"/>
            <a:chOff x="2790825" y="1977710"/>
            <a:chExt cx="1743074" cy="1628775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7648C0B-ACB3-45AB-B06F-C2AE216A75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790825" y="1977710"/>
              <a:ext cx="1685925" cy="162877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53E0916-93F6-48F4-A2A5-42521A9B17BD}"/>
                </a:ext>
              </a:extLst>
            </p:cNvPr>
            <p:cNvSpPr txBox="1"/>
            <p:nvPr/>
          </p:nvSpPr>
          <p:spPr>
            <a:xfrm>
              <a:off x="3262764" y="2112518"/>
              <a:ext cx="127113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(Not Gate)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4%</a:t>
              </a:r>
            </a:p>
          </p:txBody>
        </p:sp>
      </p:grp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C55EB4D-530B-473A-A1E2-6AE37ED6658F}"/>
              </a:ext>
            </a:extLst>
          </p:cNvPr>
          <p:cNvCxnSpPr/>
          <p:nvPr/>
        </p:nvCxnSpPr>
        <p:spPr>
          <a:xfrm>
            <a:off x="2255520" y="2766060"/>
            <a:ext cx="73152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61FC44AD-49A0-4A23-A8B1-E1A5BD6EA805}"/>
              </a:ext>
            </a:extLst>
          </p:cNvPr>
          <p:cNvCxnSpPr/>
          <p:nvPr/>
        </p:nvCxnSpPr>
        <p:spPr>
          <a:xfrm>
            <a:off x="4907280" y="2766060"/>
            <a:ext cx="731520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E9786AFB-D95A-46DE-A4C8-F6ED7F90BB42}"/>
              </a:ext>
            </a:extLst>
          </p:cNvPr>
          <p:cNvSpPr txBox="1"/>
          <p:nvPr/>
        </p:nvSpPr>
        <p:spPr>
          <a:xfrm>
            <a:off x="4853939" y="2227080"/>
            <a:ext cx="73152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 Single Cell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96FCC84-B6AE-4C72-ABA5-F18A7587686B}"/>
              </a:ext>
            </a:extLst>
          </p:cNvPr>
          <p:cNvSpPr txBox="1"/>
          <p:nvPr/>
        </p:nvSpPr>
        <p:spPr>
          <a:xfrm>
            <a:off x="5775136" y="2550261"/>
            <a:ext cx="87207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ultiplets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%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4C3E1AA-4FB8-4155-B296-5C32A2E59E20}"/>
              </a:ext>
            </a:extLst>
          </p:cNvPr>
          <p:cNvSpPr txBox="1"/>
          <p:nvPr/>
        </p:nvSpPr>
        <p:spPr>
          <a:xfrm>
            <a:off x="2168096" y="2350206"/>
            <a:ext cx="8720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5+ Neutrophils</a:t>
            </a:r>
          </a:p>
        </p:txBody>
      </p:sp>
    </p:spTree>
    <p:extLst>
      <p:ext uri="{BB962C8B-B14F-4D97-AF65-F5344CB8AC3E}">
        <p14:creationId xmlns:p14="http://schemas.microsoft.com/office/powerpoint/2010/main" val="1211876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68"/>
          <p:cNvSpPr txBox="1"/>
          <p:nvPr/>
        </p:nvSpPr>
        <p:spPr>
          <a:xfrm>
            <a:off x="304800" y="8001879"/>
            <a:ext cx="6248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: Effect of RBC lysis and fixation in the presence of antibodies on nonspecific antibody binding to monocytes and lymphocytes.</a:t>
            </a:r>
          </a:p>
        </p:txBody>
      </p:sp>
      <p:grpSp>
        <p:nvGrpSpPr>
          <p:cNvPr id="56" name="Group 55"/>
          <p:cNvGrpSpPr/>
          <p:nvPr/>
        </p:nvGrpSpPr>
        <p:grpSpPr>
          <a:xfrm>
            <a:off x="224832" y="1624163"/>
            <a:ext cx="6415186" cy="1160781"/>
            <a:chOff x="2477096" y="8110610"/>
            <a:chExt cx="6415186" cy="1160781"/>
          </a:xfrm>
        </p:grpSpPr>
        <p:sp>
          <p:nvSpPr>
            <p:cNvPr id="74" name="TextBox 73"/>
            <p:cNvSpPr txBox="1"/>
            <p:nvPr/>
          </p:nvSpPr>
          <p:spPr>
            <a:xfrm>
              <a:off x="2790044" y="8121185"/>
              <a:ext cx="128589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Lymphocytes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477096" y="8110610"/>
              <a:ext cx="424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48" name="Object 4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84109002"/>
                </p:ext>
              </p:extLst>
            </p:nvPr>
          </p:nvGraphicFramePr>
          <p:xfrm>
            <a:off x="5062078" y="8318183"/>
            <a:ext cx="1285200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3" imgW="4284000" imgH="3177360" progId="Prism5.Document">
                    <p:embed/>
                  </p:oleObj>
                </mc:Choice>
                <mc:Fallback>
                  <p:oleObj name="Prism 5" r:id="rId3" imgW="4284000" imgH="3177360" progId="Prism5.Document">
                    <p:embed/>
                    <p:pic>
                      <p:nvPicPr>
                        <p:cNvPr id="48" name="Object 47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062078" y="8318183"/>
                          <a:ext cx="1285200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9" name="Object 4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88227141"/>
                </p:ext>
              </p:extLst>
            </p:nvPr>
          </p:nvGraphicFramePr>
          <p:xfrm>
            <a:off x="6356557" y="8264723"/>
            <a:ext cx="1252260" cy="10066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5" imgW="4174200" imgH="3355560" progId="Prism5.Document">
                    <p:embed/>
                  </p:oleObj>
                </mc:Choice>
                <mc:Fallback>
                  <p:oleObj name="Prism 5" r:id="rId5" imgW="4174200" imgH="3355560" progId="Prism5.Document">
                    <p:embed/>
                    <p:pic>
                      <p:nvPicPr>
                        <p:cNvPr id="49" name="Object 48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356557" y="8264723"/>
                          <a:ext cx="1252260" cy="10066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0" name="Object 4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2887487"/>
                </p:ext>
              </p:extLst>
            </p:nvPr>
          </p:nvGraphicFramePr>
          <p:xfrm>
            <a:off x="3778615" y="8318183"/>
            <a:ext cx="1274184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7" imgW="4247280" imgH="3177360" progId="Prism5.Document">
                    <p:embed/>
                  </p:oleObj>
                </mc:Choice>
                <mc:Fallback>
                  <p:oleObj name="Prism 5" r:id="rId7" imgW="4247280" imgH="3177360" progId="Prism5.Document">
                    <p:embed/>
                    <p:pic>
                      <p:nvPicPr>
                        <p:cNvPr id="50" name="Object 49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778615" y="8318183"/>
                          <a:ext cx="1274184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1" name="Object 5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61833172"/>
                </p:ext>
              </p:extLst>
            </p:nvPr>
          </p:nvGraphicFramePr>
          <p:xfrm>
            <a:off x="7618098" y="8318183"/>
            <a:ext cx="1274184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9" imgW="4247280" imgH="3177360" progId="Prism5.Document">
                    <p:embed/>
                  </p:oleObj>
                </mc:Choice>
                <mc:Fallback>
                  <p:oleObj name="Prism 5" r:id="rId9" imgW="4247280" imgH="3177360" progId="Prism5.Document">
                    <p:embed/>
                    <p:pic>
                      <p:nvPicPr>
                        <p:cNvPr id="51" name="Object 50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7618098" y="8318183"/>
                          <a:ext cx="1274184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2" name="Object 5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34584121"/>
                </p:ext>
              </p:extLst>
            </p:nvPr>
          </p:nvGraphicFramePr>
          <p:xfrm>
            <a:off x="2503360" y="8318183"/>
            <a:ext cx="1265976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1" imgW="4219920" imgH="3177360" progId="Prism5.Document">
                    <p:embed/>
                  </p:oleObj>
                </mc:Choice>
                <mc:Fallback>
                  <p:oleObj name="Prism 5" r:id="rId11" imgW="4219920" imgH="3177360" progId="Prism5.Document">
                    <p:embed/>
                    <p:pic>
                      <p:nvPicPr>
                        <p:cNvPr id="52" name="Object 51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503360" y="8318183"/>
                          <a:ext cx="1265976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57" name="Group 56"/>
          <p:cNvGrpSpPr/>
          <p:nvPr/>
        </p:nvGrpSpPr>
        <p:grpSpPr>
          <a:xfrm>
            <a:off x="224832" y="304800"/>
            <a:ext cx="6426202" cy="1215056"/>
            <a:chOff x="2477096" y="6791247"/>
            <a:chExt cx="6426202" cy="1215056"/>
          </a:xfrm>
        </p:grpSpPr>
        <p:sp>
          <p:nvSpPr>
            <p:cNvPr id="72" name="TextBox 71"/>
            <p:cNvSpPr txBox="1"/>
            <p:nvPr/>
          </p:nvSpPr>
          <p:spPr>
            <a:xfrm>
              <a:off x="2790044" y="6801822"/>
              <a:ext cx="128589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Monocytes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477096" y="6791247"/>
              <a:ext cx="424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25" name="Object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14667035"/>
                </p:ext>
              </p:extLst>
            </p:nvPr>
          </p:nvGraphicFramePr>
          <p:xfrm>
            <a:off x="5051117" y="7053095"/>
            <a:ext cx="1285200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3" imgW="4284000" imgH="3177360" progId="Prism5.Document">
                    <p:embed/>
                  </p:oleObj>
                </mc:Choice>
                <mc:Fallback>
                  <p:oleObj name="Prism 5" r:id="rId13" imgW="4284000" imgH="3177360" progId="Prism5.Document">
                    <p:embed/>
                    <p:pic>
                      <p:nvPicPr>
                        <p:cNvPr id="25" name="Object 24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051117" y="7053095"/>
                          <a:ext cx="1285200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87517470"/>
                </p:ext>
              </p:extLst>
            </p:nvPr>
          </p:nvGraphicFramePr>
          <p:xfrm>
            <a:off x="6334608" y="7053095"/>
            <a:ext cx="1285200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5" imgW="4284000" imgH="3177360" progId="Prism5.Document">
                    <p:embed/>
                  </p:oleObj>
                </mc:Choice>
                <mc:Fallback>
                  <p:oleObj name="Prism 5" r:id="rId15" imgW="4284000" imgH="3177360" progId="Prism5.Document">
                    <p:embed/>
                    <p:pic>
                      <p:nvPicPr>
                        <p:cNvPr id="26" name="Object 25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6334608" y="7053095"/>
                          <a:ext cx="1285200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1707866"/>
                </p:ext>
              </p:extLst>
            </p:nvPr>
          </p:nvGraphicFramePr>
          <p:xfrm>
            <a:off x="3767627" y="7053095"/>
            <a:ext cx="1285200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7" imgW="4284000" imgH="3177360" progId="Prism5.Document">
                    <p:embed/>
                  </p:oleObj>
                </mc:Choice>
                <mc:Fallback>
                  <p:oleObj name="Prism 5" r:id="rId17" imgW="4284000" imgH="3177360" progId="Prism5.Document">
                    <p:embed/>
                    <p:pic>
                      <p:nvPicPr>
                        <p:cNvPr id="29" name="Object 28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3767627" y="7053095"/>
                          <a:ext cx="1285200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4" name="Object 5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5195668"/>
                </p:ext>
              </p:extLst>
            </p:nvPr>
          </p:nvGraphicFramePr>
          <p:xfrm>
            <a:off x="2503360" y="7053095"/>
            <a:ext cx="1265976" cy="9532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9" imgW="4219920" imgH="3177360" progId="Prism5.Document">
                    <p:embed/>
                  </p:oleObj>
                </mc:Choice>
                <mc:Fallback>
                  <p:oleObj name="Prism 5" r:id="rId19" imgW="4219920" imgH="3177360" progId="Prism5.Document">
                    <p:embed/>
                    <p:pic>
                      <p:nvPicPr>
                        <p:cNvPr id="54" name="Object 53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2503360" y="7053095"/>
                          <a:ext cx="1265976" cy="9532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5" name="Object 5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33495975"/>
                </p:ext>
              </p:extLst>
            </p:nvPr>
          </p:nvGraphicFramePr>
          <p:xfrm>
            <a:off x="7618098" y="6969395"/>
            <a:ext cx="1285200" cy="10369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1" imgW="4284000" imgH="3456360" progId="Prism5.Document">
                    <p:embed/>
                  </p:oleObj>
                </mc:Choice>
                <mc:Fallback>
                  <p:oleObj name="Prism 5" r:id="rId21" imgW="4284000" imgH="3456360" progId="Prism5.Document">
                    <p:embed/>
                    <p:pic>
                      <p:nvPicPr>
                        <p:cNvPr id="55" name="Object 54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7618098" y="6969395"/>
                          <a:ext cx="1285200" cy="10369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3201639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221426" y="219599"/>
            <a:ext cx="3202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21426" y="1668166"/>
            <a:ext cx="2742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04800" y="8251267"/>
            <a:ext cx="624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: Staining temperature trends hold in EDTA and heparin tubes. 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45376" y="397734"/>
            <a:ext cx="877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DT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74009" y="1773899"/>
            <a:ext cx="8774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261938" y="783693"/>
            <a:ext cx="6565169" cy="814920"/>
            <a:chOff x="261938" y="783693"/>
            <a:chExt cx="6565169" cy="814920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24583859"/>
                </p:ext>
              </p:extLst>
            </p:nvPr>
          </p:nvGraphicFramePr>
          <p:xfrm>
            <a:off x="261938" y="784225"/>
            <a:ext cx="1463675" cy="8143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3" imgW="4724620" imgH="2624082" progId="Prism5.Document">
                    <p:embed/>
                  </p:oleObj>
                </mc:Choice>
                <mc:Fallback>
                  <p:oleObj name="Prism 5" r:id="rId3" imgW="4724620" imgH="2624082" progId="Prism5.Document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61938" y="784225"/>
                          <a:ext cx="1463675" cy="8143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97893450"/>
                </p:ext>
              </p:extLst>
            </p:nvPr>
          </p:nvGraphicFramePr>
          <p:xfrm>
            <a:off x="1542388" y="783694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5" imgW="4695480" imgH="2627280" progId="Prism5.Document">
                    <p:embed/>
                  </p:oleObj>
                </mc:Choice>
                <mc:Fallback>
                  <p:oleObj name="Prism 5" r:id="rId5" imgW="4695480" imgH="2627280" progId="Prism5.Document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542388" y="783694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0627272"/>
                </p:ext>
              </p:extLst>
            </p:nvPr>
          </p:nvGraphicFramePr>
          <p:xfrm>
            <a:off x="2818762" y="783694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7" imgW="4695480" imgH="2627280" progId="Prism5.Document">
                    <p:embed/>
                  </p:oleObj>
                </mc:Choice>
                <mc:Fallback>
                  <p:oleObj name="Prism 5" r:id="rId7" imgW="4695480" imgH="2627280" progId="Prism5.Document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818762" y="783694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5683114"/>
                </p:ext>
              </p:extLst>
            </p:nvPr>
          </p:nvGraphicFramePr>
          <p:xfrm>
            <a:off x="4095136" y="783693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9" imgW="4695480" imgH="2627280" progId="Prism5.Document">
                    <p:embed/>
                  </p:oleObj>
                </mc:Choice>
                <mc:Fallback>
                  <p:oleObj name="Prism 5" r:id="rId9" imgW="4695480" imgH="2627280" progId="Prism5.Document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095136" y="783693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54199261"/>
                </p:ext>
              </p:extLst>
            </p:nvPr>
          </p:nvGraphicFramePr>
          <p:xfrm>
            <a:off x="5371508" y="783693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1" imgW="4695480" imgH="2627280" progId="Prism5.Document">
                    <p:embed/>
                  </p:oleObj>
                </mc:Choice>
                <mc:Fallback>
                  <p:oleObj name="Prism 5" r:id="rId11" imgW="4695480" imgH="2627280" progId="Prism5.Document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371508" y="783693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3" name="Group 12"/>
          <p:cNvGrpSpPr/>
          <p:nvPr/>
        </p:nvGrpSpPr>
        <p:grpSpPr>
          <a:xfrm>
            <a:off x="266014" y="2081856"/>
            <a:ext cx="6561093" cy="814460"/>
            <a:chOff x="266014" y="2243781"/>
            <a:chExt cx="6561093" cy="814460"/>
          </a:xfrm>
        </p:grpSpPr>
        <p:graphicFrame>
          <p:nvGraphicFramePr>
            <p:cNvPr id="8" name="Object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67536601"/>
                </p:ext>
              </p:extLst>
            </p:nvPr>
          </p:nvGraphicFramePr>
          <p:xfrm>
            <a:off x="266014" y="2243784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3" imgW="4695480" imgH="2627280" progId="Prism5.Document">
                    <p:embed/>
                  </p:oleObj>
                </mc:Choice>
                <mc:Fallback>
                  <p:oleObj name="Prism 5" r:id="rId13" imgW="4695480" imgH="2627280" progId="Prism5.Document">
                    <p:embed/>
                    <p:pic>
                      <p:nvPicPr>
                        <p:cNvPr id="8" name="Object 7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66014" y="2243784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62602711"/>
                </p:ext>
              </p:extLst>
            </p:nvPr>
          </p:nvGraphicFramePr>
          <p:xfrm>
            <a:off x="1542388" y="2243783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5" imgW="4695480" imgH="2627280" progId="Prism5.Document">
                    <p:embed/>
                  </p:oleObj>
                </mc:Choice>
                <mc:Fallback>
                  <p:oleObj name="Prism 5" r:id="rId15" imgW="4695480" imgH="2627280" progId="Prism5.Document">
                    <p:embed/>
                    <p:pic>
                      <p:nvPicPr>
                        <p:cNvPr id="9" name="Object 8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542388" y="2243783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78848627"/>
                </p:ext>
              </p:extLst>
            </p:nvPr>
          </p:nvGraphicFramePr>
          <p:xfrm>
            <a:off x="2818762" y="2243782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7" imgW="4695480" imgH="2627280" progId="Prism5.Document">
                    <p:embed/>
                  </p:oleObj>
                </mc:Choice>
                <mc:Fallback>
                  <p:oleObj name="Prism 5" r:id="rId17" imgW="4695480" imgH="2627280" progId="Prism5.Document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818762" y="2243782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ct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48198761"/>
                </p:ext>
              </p:extLst>
            </p:nvPr>
          </p:nvGraphicFramePr>
          <p:xfrm>
            <a:off x="4095136" y="2243782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9" imgW="4695480" imgH="2627280" progId="Prism5.Document">
                    <p:embed/>
                  </p:oleObj>
                </mc:Choice>
                <mc:Fallback>
                  <p:oleObj name="Prism 5" r:id="rId19" imgW="4695480" imgH="2627280" progId="Prism5.Document">
                    <p:embed/>
                    <p:pic>
                      <p:nvPicPr>
                        <p:cNvPr id="11" name="Object 10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4095136" y="2243782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56670015"/>
                </p:ext>
              </p:extLst>
            </p:nvPr>
          </p:nvGraphicFramePr>
          <p:xfrm>
            <a:off x="5371508" y="2243781"/>
            <a:ext cx="1455599" cy="8144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1" imgW="4695480" imgH="2627280" progId="Prism5.Document">
                    <p:embed/>
                  </p:oleObj>
                </mc:Choice>
                <mc:Fallback>
                  <p:oleObj name="Prism 5" r:id="rId21" imgW="4695480" imgH="2627280" progId="Prism5.Document">
                    <p:embed/>
                    <p:pic>
                      <p:nvPicPr>
                        <p:cNvPr id="12" name="Object 11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5371508" y="2243781"/>
                          <a:ext cx="1455599" cy="8144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5143681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202753" y="249242"/>
            <a:ext cx="424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02753" y="1411688"/>
            <a:ext cx="424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04800" y="8251266"/>
            <a:ext cx="624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: The effects of anticoagulant type and sample processing delays on neutrophil phenotype.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21521" y="2574134"/>
            <a:ext cx="424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21521" y="3736580"/>
            <a:ext cx="424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240807" y="382588"/>
            <a:ext cx="6569568" cy="964975"/>
            <a:chOff x="240807" y="321628"/>
            <a:chExt cx="6569568" cy="964975"/>
          </a:xfrm>
        </p:grpSpPr>
        <p:grpSp>
          <p:nvGrpSpPr>
            <p:cNvPr id="35" name="Group 34"/>
            <p:cNvGrpSpPr/>
            <p:nvPr/>
          </p:nvGrpSpPr>
          <p:grpSpPr>
            <a:xfrm>
              <a:off x="603250" y="321628"/>
              <a:ext cx="6207125" cy="906462"/>
              <a:chOff x="489917" y="33090"/>
              <a:chExt cx="6207125" cy="906462"/>
            </a:xfrm>
          </p:grpSpPr>
          <p:graphicFrame>
            <p:nvGraphicFramePr>
              <p:cNvPr id="36" name="Object 3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98820627"/>
                  </p:ext>
                </p:extLst>
              </p:nvPr>
            </p:nvGraphicFramePr>
            <p:xfrm>
              <a:off x="489917" y="33090"/>
              <a:ext cx="1355725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" imgW="4675086" imgH="3126987" progId="Prism9.Document">
                      <p:embed/>
                    </p:oleObj>
                  </mc:Choice>
                  <mc:Fallback>
                    <p:oleObj name="Prism 9" r:id="rId3" imgW="4675086" imgH="3126987" progId="Prism9.Document">
                      <p:embed/>
                      <p:pic>
                        <p:nvPicPr>
                          <p:cNvPr id="36" name="Object 35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489917" y="33090"/>
                            <a:ext cx="1355725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7" name="Object 3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75788844"/>
                  </p:ext>
                </p:extLst>
              </p:nvPr>
            </p:nvGraphicFramePr>
            <p:xfrm>
              <a:off x="1704355" y="33090"/>
              <a:ext cx="1358900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5" imgW="4682645" imgH="3126987" progId="Prism9.Document">
                      <p:embed/>
                    </p:oleObj>
                  </mc:Choice>
                  <mc:Fallback>
                    <p:oleObj name="Prism 9" r:id="rId5" imgW="4682645" imgH="3126987" progId="Prism9.Document">
                      <p:embed/>
                      <p:pic>
                        <p:nvPicPr>
                          <p:cNvPr id="37" name="Object 36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1704355" y="33090"/>
                            <a:ext cx="1358900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8" name="Object 3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58325105"/>
                  </p:ext>
                </p:extLst>
              </p:nvPr>
            </p:nvGraphicFramePr>
            <p:xfrm>
              <a:off x="2915617" y="33090"/>
              <a:ext cx="1355725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7" imgW="4675086" imgH="3126987" progId="Prism9.Document">
                      <p:embed/>
                    </p:oleObj>
                  </mc:Choice>
                  <mc:Fallback>
                    <p:oleObj name="Prism 9" r:id="rId7" imgW="4675086" imgH="3126987" progId="Prism9.Document">
                      <p:embed/>
                      <p:pic>
                        <p:nvPicPr>
                          <p:cNvPr id="38" name="Object 37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2915617" y="33090"/>
                            <a:ext cx="1355725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9" name="Object 3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3013226"/>
                  </p:ext>
                </p:extLst>
              </p:nvPr>
            </p:nvGraphicFramePr>
            <p:xfrm>
              <a:off x="5341317" y="33090"/>
              <a:ext cx="1355725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9" imgW="4675086" imgH="3126987" progId="Prism9.Document">
                      <p:embed/>
                    </p:oleObj>
                  </mc:Choice>
                  <mc:Fallback>
                    <p:oleObj name="Prism 9" r:id="rId9" imgW="4675086" imgH="3126987" progId="Prism9.Document">
                      <p:embed/>
                      <p:pic>
                        <p:nvPicPr>
                          <p:cNvPr id="39" name="Object 38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5341317" y="33090"/>
                            <a:ext cx="1355725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0" name="Object 3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67314163"/>
                  </p:ext>
                </p:extLst>
              </p:nvPr>
            </p:nvGraphicFramePr>
            <p:xfrm>
              <a:off x="4125292" y="33090"/>
              <a:ext cx="1357313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1" imgW="4682645" imgH="3126987" progId="Prism9.Document">
                      <p:embed/>
                    </p:oleObj>
                  </mc:Choice>
                  <mc:Fallback>
                    <p:oleObj name="Prism 9" r:id="rId11" imgW="4682645" imgH="3126987" progId="Prism9.Document">
                      <p:embed/>
                      <p:pic>
                        <p:nvPicPr>
                          <p:cNvPr id="40" name="Object 39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4125292" y="33090"/>
                            <a:ext cx="1357313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5" name="TextBox 64"/>
            <p:cNvSpPr txBox="1"/>
            <p:nvPr/>
          </p:nvSpPr>
          <p:spPr>
            <a:xfrm rot="16200000">
              <a:off x="-103448" y="680738"/>
              <a:ext cx="95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EDTA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43894" y="1525548"/>
            <a:ext cx="6568069" cy="950120"/>
            <a:chOff x="243894" y="1511636"/>
            <a:chExt cx="6568069" cy="950120"/>
          </a:xfrm>
        </p:grpSpPr>
        <p:grpSp>
          <p:nvGrpSpPr>
            <p:cNvPr id="42" name="Group 41"/>
            <p:cNvGrpSpPr/>
            <p:nvPr/>
          </p:nvGrpSpPr>
          <p:grpSpPr>
            <a:xfrm>
              <a:off x="601663" y="1527551"/>
              <a:ext cx="6210300" cy="906462"/>
              <a:chOff x="488330" y="2007492"/>
              <a:chExt cx="6210300" cy="906462"/>
            </a:xfrm>
          </p:grpSpPr>
          <p:graphicFrame>
            <p:nvGraphicFramePr>
              <p:cNvPr id="43" name="Object 4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47554963"/>
                  </p:ext>
                </p:extLst>
              </p:nvPr>
            </p:nvGraphicFramePr>
            <p:xfrm>
              <a:off x="488330" y="2007492"/>
              <a:ext cx="1357312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3" imgW="4675086" imgH="3126987" progId="Prism9.Document">
                      <p:embed/>
                    </p:oleObj>
                  </mc:Choice>
                  <mc:Fallback>
                    <p:oleObj name="Prism 9" r:id="rId13" imgW="4675086" imgH="3126987" progId="Prism9.Document">
                      <p:embed/>
                      <p:pic>
                        <p:nvPicPr>
                          <p:cNvPr id="43" name="Object 42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488330" y="2007492"/>
                            <a:ext cx="1357312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4" name="Object 4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53032226"/>
                  </p:ext>
                </p:extLst>
              </p:nvPr>
            </p:nvGraphicFramePr>
            <p:xfrm>
              <a:off x="1702767" y="2007492"/>
              <a:ext cx="1357313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5" imgW="4682645" imgH="3126987" progId="Prism9.Document">
                      <p:embed/>
                    </p:oleObj>
                  </mc:Choice>
                  <mc:Fallback>
                    <p:oleObj name="Prism 9" r:id="rId15" imgW="4682645" imgH="3126987" progId="Prism9.Document">
                      <p:embed/>
                      <p:pic>
                        <p:nvPicPr>
                          <p:cNvPr id="44" name="Object 43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1702767" y="2007492"/>
                            <a:ext cx="1357313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5" name="Object 4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90784014"/>
                  </p:ext>
                </p:extLst>
              </p:nvPr>
            </p:nvGraphicFramePr>
            <p:xfrm>
              <a:off x="2917205" y="2007492"/>
              <a:ext cx="1354137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7" imgW="4675086" imgH="3126987" progId="Prism9.Document">
                      <p:embed/>
                    </p:oleObj>
                  </mc:Choice>
                  <mc:Fallback>
                    <p:oleObj name="Prism 9" r:id="rId17" imgW="4675086" imgH="3126987" progId="Prism9.Document">
                      <p:embed/>
                      <p:pic>
                        <p:nvPicPr>
                          <p:cNvPr id="45" name="Object 44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2917205" y="2007492"/>
                            <a:ext cx="1354137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6" name="Object 4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75988512"/>
                  </p:ext>
                </p:extLst>
              </p:nvPr>
            </p:nvGraphicFramePr>
            <p:xfrm>
              <a:off x="5342905" y="2007492"/>
              <a:ext cx="1355725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19" imgW="4675086" imgH="3126987" progId="Prism9.Document">
                      <p:embed/>
                    </p:oleObj>
                  </mc:Choice>
                  <mc:Fallback>
                    <p:oleObj name="Prism 9" r:id="rId19" imgW="4675086" imgH="3126987" progId="Prism9.Document">
                      <p:embed/>
                      <p:pic>
                        <p:nvPicPr>
                          <p:cNvPr id="46" name="Object 45"/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5342905" y="2007492"/>
                            <a:ext cx="1355725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7" name="Object 4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61886203"/>
                  </p:ext>
                </p:extLst>
              </p:nvPr>
            </p:nvGraphicFramePr>
            <p:xfrm>
              <a:off x="4128467" y="2007492"/>
              <a:ext cx="1355725" cy="906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1" imgW="4682645" imgH="3126987" progId="Prism9.Document">
                      <p:embed/>
                    </p:oleObj>
                  </mc:Choice>
                  <mc:Fallback>
                    <p:oleObj name="Prism 9" r:id="rId21" imgW="4682645" imgH="3126987" progId="Prism9.Document">
                      <p:embed/>
                      <p:pic>
                        <p:nvPicPr>
                          <p:cNvPr id="47" name="Object 46"/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4128467" y="2007492"/>
                            <a:ext cx="1355725" cy="906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6" name="TextBox 65"/>
            <p:cNvSpPr txBox="1"/>
            <p:nvPr/>
          </p:nvSpPr>
          <p:spPr>
            <a:xfrm rot="16200000">
              <a:off x="-100361" y="1855891"/>
              <a:ext cx="95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EDTA</a:t>
              </a: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238256" y="2644775"/>
            <a:ext cx="6581644" cy="995515"/>
            <a:chOff x="238256" y="2859163"/>
            <a:chExt cx="6581644" cy="995515"/>
          </a:xfrm>
        </p:grpSpPr>
        <p:grpSp>
          <p:nvGrpSpPr>
            <p:cNvPr id="52" name="Group 51"/>
            <p:cNvGrpSpPr/>
            <p:nvPr/>
          </p:nvGrpSpPr>
          <p:grpSpPr>
            <a:xfrm>
              <a:off x="601663" y="2859163"/>
              <a:ext cx="6218237" cy="908050"/>
              <a:chOff x="488330" y="3978406"/>
              <a:chExt cx="6218237" cy="908050"/>
            </a:xfrm>
          </p:grpSpPr>
          <p:graphicFrame>
            <p:nvGraphicFramePr>
              <p:cNvPr id="53" name="Object 5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72824411"/>
                  </p:ext>
                </p:extLst>
              </p:nvPr>
            </p:nvGraphicFramePr>
            <p:xfrm>
              <a:off x="488330" y="3978406"/>
              <a:ext cx="1357312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3" imgW="4675086" imgH="3126987" progId="Prism9.Document">
                      <p:embed/>
                    </p:oleObj>
                  </mc:Choice>
                  <mc:Fallback>
                    <p:oleObj name="Prism 9" r:id="rId23" imgW="4675086" imgH="3126987" progId="Prism9.Document">
                      <p:embed/>
                      <p:pic>
                        <p:nvPicPr>
                          <p:cNvPr id="53" name="Object 52"/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488330" y="3978406"/>
                            <a:ext cx="1357312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4" name="Object 5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26343956"/>
                  </p:ext>
                </p:extLst>
              </p:nvPr>
            </p:nvGraphicFramePr>
            <p:xfrm>
              <a:off x="1704355" y="3978406"/>
              <a:ext cx="1358900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25" imgW="4682645" imgH="3126987" progId="Prism5.Document">
                      <p:embed/>
                    </p:oleObj>
                  </mc:Choice>
                  <mc:Fallback>
                    <p:oleObj name="Prism 5" r:id="rId25" imgW="4682645" imgH="3126987" progId="Prism5.Document">
                      <p:embed/>
                      <p:pic>
                        <p:nvPicPr>
                          <p:cNvPr id="54" name="Object 53"/>
                          <p:cNvPicPr/>
                          <p:nvPr/>
                        </p:nvPicPr>
                        <p:blipFill>
                          <a:blip r:embed="rId26"/>
                          <a:stretch>
                            <a:fillRect/>
                          </a:stretch>
                        </p:blipFill>
                        <p:spPr>
                          <a:xfrm>
                            <a:off x="1704355" y="3978406"/>
                            <a:ext cx="1358900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5" name="Object 5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071338"/>
                  </p:ext>
                </p:extLst>
              </p:nvPr>
            </p:nvGraphicFramePr>
            <p:xfrm>
              <a:off x="2920380" y="3978406"/>
              <a:ext cx="1355725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27" imgW="4675086" imgH="3126987" progId="Prism5.Document">
                      <p:embed/>
                    </p:oleObj>
                  </mc:Choice>
                  <mc:Fallback>
                    <p:oleObj name="Prism 5" r:id="rId27" imgW="4675086" imgH="3126987" progId="Prism5.Document">
                      <p:embed/>
                      <p:pic>
                        <p:nvPicPr>
                          <p:cNvPr id="55" name="Object 54"/>
                          <p:cNvPicPr/>
                          <p:nvPr/>
                        </p:nvPicPr>
                        <p:blipFill>
                          <a:blip r:embed="rId28"/>
                          <a:stretch>
                            <a:fillRect/>
                          </a:stretch>
                        </p:blipFill>
                        <p:spPr>
                          <a:xfrm>
                            <a:off x="2920380" y="3978406"/>
                            <a:ext cx="1355725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6" name="Object 5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60985454"/>
                  </p:ext>
                </p:extLst>
              </p:nvPr>
            </p:nvGraphicFramePr>
            <p:xfrm>
              <a:off x="5350842" y="3978406"/>
              <a:ext cx="1355725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29" imgW="4675086" imgH="3126987" progId="Prism5.Document">
                      <p:embed/>
                    </p:oleObj>
                  </mc:Choice>
                  <mc:Fallback>
                    <p:oleObj name="Prism 5" r:id="rId29" imgW="4675086" imgH="3126987" progId="Prism5.Document">
                      <p:embed/>
                      <p:pic>
                        <p:nvPicPr>
                          <p:cNvPr id="56" name="Object 55"/>
                          <p:cNvPicPr/>
                          <p:nvPr/>
                        </p:nvPicPr>
                        <p:blipFill>
                          <a:blip r:embed="rId30"/>
                          <a:stretch>
                            <a:fillRect/>
                          </a:stretch>
                        </p:blipFill>
                        <p:spPr>
                          <a:xfrm>
                            <a:off x="5350842" y="3978406"/>
                            <a:ext cx="1355725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7" name="Object 5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89095548"/>
                  </p:ext>
                </p:extLst>
              </p:nvPr>
            </p:nvGraphicFramePr>
            <p:xfrm>
              <a:off x="4134817" y="3978406"/>
              <a:ext cx="1357313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31" imgW="4682645" imgH="3126987" progId="Prism5.Document">
                      <p:embed/>
                    </p:oleObj>
                  </mc:Choice>
                  <mc:Fallback>
                    <p:oleObj name="Prism 5" r:id="rId31" imgW="4682645" imgH="3126987" progId="Prism5.Document">
                      <p:embed/>
                      <p:pic>
                        <p:nvPicPr>
                          <p:cNvPr id="57" name="Object 56"/>
                          <p:cNvPicPr/>
                          <p:nvPr/>
                        </p:nvPicPr>
                        <p:blipFill>
                          <a:blip r:embed="rId32"/>
                          <a:stretch>
                            <a:fillRect/>
                          </a:stretch>
                        </p:blipFill>
                        <p:spPr>
                          <a:xfrm>
                            <a:off x="4134817" y="3978406"/>
                            <a:ext cx="1357313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7" name="TextBox 66"/>
            <p:cNvSpPr txBox="1"/>
            <p:nvPr/>
          </p:nvSpPr>
          <p:spPr>
            <a:xfrm rot="16200000">
              <a:off x="-105999" y="3248813"/>
              <a:ext cx="95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Heparin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238256" y="3822700"/>
            <a:ext cx="6581644" cy="1016497"/>
            <a:chOff x="238256" y="4055920"/>
            <a:chExt cx="6581644" cy="1016497"/>
          </a:xfrm>
        </p:grpSpPr>
        <p:grpSp>
          <p:nvGrpSpPr>
            <p:cNvPr id="59" name="Group 58"/>
            <p:cNvGrpSpPr/>
            <p:nvPr/>
          </p:nvGrpSpPr>
          <p:grpSpPr>
            <a:xfrm>
              <a:off x="606425" y="4055920"/>
              <a:ext cx="6213475" cy="908050"/>
              <a:chOff x="493092" y="5889151"/>
              <a:chExt cx="6213475" cy="908050"/>
            </a:xfrm>
          </p:grpSpPr>
          <p:graphicFrame>
            <p:nvGraphicFramePr>
              <p:cNvPr id="60" name="Object 5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9028436"/>
                  </p:ext>
                </p:extLst>
              </p:nvPr>
            </p:nvGraphicFramePr>
            <p:xfrm>
              <a:off x="493092" y="5889151"/>
              <a:ext cx="1357313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33" imgW="4675086" imgH="3126987" progId="Prism5.Document">
                      <p:embed/>
                    </p:oleObj>
                  </mc:Choice>
                  <mc:Fallback>
                    <p:oleObj name="Prism 5" r:id="rId33" imgW="4675086" imgH="3126987" progId="Prism5.Document">
                      <p:embed/>
                      <p:pic>
                        <p:nvPicPr>
                          <p:cNvPr id="60" name="Object 59"/>
                          <p:cNvPicPr/>
                          <p:nvPr/>
                        </p:nvPicPr>
                        <p:blipFill>
                          <a:blip r:embed="rId34"/>
                          <a:stretch>
                            <a:fillRect/>
                          </a:stretch>
                        </p:blipFill>
                        <p:spPr>
                          <a:xfrm>
                            <a:off x="493092" y="5889151"/>
                            <a:ext cx="1357313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1" name="Object 6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10755649"/>
                  </p:ext>
                </p:extLst>
              </p:nvPr>
            </p:nvGraphicFramePr>
            <p:xfrm>
              <a:off x="1707530" y="5889151"/>
              <a:ext cx="1358900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5" imgW="4682645" imgH="3126987" progId="Prism9.Document">
                      <p:embed/>
                    </p:oleObj>
                  </mc:Choice>
                  <mc:Fallback>
                    <p:oleObj name="Prism 9" r:id="rId35" imgW="4682645" imgH="3126987" progId="Prism9.Document">
                      <p:embed/>
                      <p:pic>
                        <p:nvPicPr>
                          <p:cNvPr id="61" name="Object 60"/>
                          <p:cNvPicPr/>
                          <p:nvPr/>
                        </p:nvPicPr>
                        <p:blipFill>
                          <a:blip r:embed="rId36"/>
                          <a:stretch>
                            <a:fillRect/>
                          </a:stretch>
                        </p:blipFill>
                        <p:spPr>
                          <a:xfrm>
                            <a:off x="1707530" y="5889151"/>
                            <a:ext cx="1358900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2" name="Object 6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27808912"/>
                  </p:ext>
                </p:extLst>
              </p:nvPr>
            </p:nvGraphicFramePr>
            <p:xfrm>
              <a:off x="2923555" y="5889151"/>
              <a:ext cx="1355725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37" imgW="4675086" imgH="3126987" progId="Prism5.Document">
                      <p:embed/>
                    </p:oleObj>
                  </mc:Choice>
                  <mc:Fallback>
                    <p:oleObj name="Prism 5" r:id="rId37" imgW="4675086" imgH="3126987" progId="Prism5.Document">
                      <p:embed/>
                      <p:pic>
                        <p:nvPicPr>
                          <p:cNvPr id="62" name="Object 61"/>
                          <p:cNvPicPr/>
                          <p:nvPr/>
                        </p:nvPicPr>
                        <p:blipFill>
                          <a:blip r:embed="rId38"/>
                          <a:stretch>
                            <a:fillRect/>
                          </a:stretch>
                        </p:blipFill>
                        <p:spPr>
                          <a:xfrm>
                            <a:off x="2923555" y="5889151"/>
                            <a:ext cx="1355725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3" name="Object 6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39327253"/>
                  </p:ext>
                </p:extLst>
              </p:nvPr>
            </p:nvGraphicFramePr>
            <p:xfrm>
              <a:off x="5350842" y="5889151"/>
              <a:ext cx="1355725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39" imgW="4675086" imgH="3126987" progId="Prism5.Document">
                      <p:embed/>
                    </p:oleObj>
                  </mc:Choice>
                  <mc:Fallback>
                    <p:oleObj name="Prism 5" r:id="rId39" imgW="4675086" imgH="3126987" progId="Prism5.Document">
                      <p:embed/>
                      <p:pic>
                        <p:nvPicPr>
                          <p:cNvPr id="63" name="Object 62"/>
                          <p:cNvPicPr/>
                          <p:nvPr/>
                        </p:nvPicPr>
                        <p:blipFill>
                          <a:blip r:embed="rId40"/>
                          <a:stretch>
                            <a:fillRect/>
                          </a:stretch>
                        </p:blipFill>
                        <p:spPr>
                          <a:xfrm>
                            <a:off x="5350842" y="5889151"/>
                            <a:ext cx="1355725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4" name="Object 6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231123917"/>
                  </p:ext>
                </p:extLst>
              </p:nvPr>
            </p:nvGraphicFramePr>
            <p:xfrm>
              <a:off x="4136405" y="5889151"/>
              <a:ext cx="1355725" cy="9080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41" imgW="4682645" imgH="3126987" progId="Prism5.Document">
                      <p:embed/>
                    </p:oleObj>
                  </mc:Choice>
                  <mc:Fallback>
                    <p:oleObj name="Prism 5" r:id="rId41" imgW="4682645" imgH="3126987" progId="Prism5.Document">
                      <p:embed/>
                      <p:pic>
                        <p:nvPicPr>
                          <p:cNvPr id="64" name="Object 63"/>
                          <p:cNvPicPr/>
                          <p:nvPr/>
                        </p:nvPicPr>
                        <p:blipFill>
                          <a:blip r:embed="rId42"/>
                          <a:stretch>
                            <a:fillRect/>
                          </a:stretch>
                        </p:blipFill>
                        <p:spPr>
                          <a:xfrm>
                            <a:off x="4136405" y="5889151"/>
                            <a:ext cx="1355725" cy="9080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8" name="TextBox 67"/>
            <p:cNvSpPr txBox="1"/>
            <p:nvPr/>
          </p:nvSpPr>
          <p:spPr>
            <a:xfrm rot="16200000">
              <a:off x="-105999" y="4466552"/>
              <a:ext cx="95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Hepar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810252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3134078"/>
              </p:ext>
            </p:extLst>
          </p:nvPr>
        </p:nvGraphicFramePr>
        <p:xfrm>
          <a:off x="390007" y="443620"/>
          <a:ext cx="5915024" cy="3498367"/>
        </p:xfrm>
        <a:graphic>
          <a:graphicData uri="http://schemas.openxmlformats.org/drawingml/2006/table">
            <a:tbl>
              <a:tblPr/>
              <a:tblGrid>
                <a:gridCol w="11611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270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90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2369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2705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270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0950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body Reactivity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(Anti-Human)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one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orescent Tag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pany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alogue #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RI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KT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7322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56199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KT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730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571907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1b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CRF44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-Cy5.5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1328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10933428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4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D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/Fire</a:t>
                      </a:r>
                      <a:r>
                        <a:rPr lang="en-US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</a:t>
                      </a: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0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7120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572099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5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98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Fluor450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science</a:t>
                      </a:r>
                      <a:r>
                        <a:rPr lang="en-US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-0159-42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01666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CB1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Bioscience</a:t>
                      </a:r>
                      <a:r>
                        <a:rPr lang="en-US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-0168-42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01666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B19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605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2244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562015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62L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REG-5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71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078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74044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66b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10F5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5104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31449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77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M-16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580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56428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193 (CCR3)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E8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V510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3017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2737988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LA-DR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24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/Cy7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761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_493588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 (IgG1</a:t>
                      </a:r>
                      <a:r>
                        <a:rPr lang="el-G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)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PC-2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/Fire</a:t>
                      </a:r>
                      <a:r>
                        <a:rPr lang="en-US" sz="7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</a:t>
                      </a: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0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0196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 (IgG1</a:t>
                      </a:r>
                      <a:r>
                        <a:rPr lang="el-G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)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PC-2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TC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0110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 (IgG1</a:t>
                      </a:r>
                      <a:r>
                        <a:rPr lang="el-G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)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PC-2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0114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 (IgG1</a:t>
                      </a:r>
                      <a:r>
                        <a:rPr lang="el-G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)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PC-21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rCP-Cy5.5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0150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75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type (IgG2a</a:t>
                      </a:r>
                      <a:r>
                        <a:rPr lang="el-G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κ)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OPC-173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-Cy7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0232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9379" marR="9379" marT="937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04800" y="8500646"/>
            <a:ext cx="41986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: Antibodies.</a:t>
            </a:r>
          </a:p>
        </p:txBody>
      </p:sp>
    </p:spTree>
    <p:extLst>
      <p:ext uri="{BB962C8B-B14F-4D97-AF65-F5344CB8AC3E}">
        <p14:creationId xmlns:p14="http://schemas.microsoft.com/office/powerpoint/2010/main" val="24676486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98058"/>
              </p:ext>
            </p:extLst>
          </p:nvPr>
        </p:nvGraphicFramePr>
        <p:xfrm>
          <a:off x="1095570" y="622941"/>
          <a:ext cx="4467685" cy="5234393"/>
        </p:xfrm>
        <a:graphic>
          <a:graphicData uri="http://schemas.openxmlformats.org/drawingml/2006/table">
            <a:tbl>
              <a:tblPr/>
              <a:tblGrid>
                <a:gridCol w="20304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872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4992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1235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agent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pany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alogue #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PB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rning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-031-CV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DTA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rning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-034-CI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parin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gma-Aldric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3393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coll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sher Scientific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-001-751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PAQUE-1077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gma-Aldrich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889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ISTOPAQUE-1119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gma-Aldrich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191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dimentation Buffer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tenyi</a:t>
                      </a:r>
                      <a:r>
                        <a:rPr lang="en-US" sz="7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7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tec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racellular (IC) Fixation Buffer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0-8222-49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X 1-step Fixation and Lysis Buffer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vitrogen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0-5333-54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tal Bovine Serum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lanta Biological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1150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uman Serum Type AB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sher BioReagent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P2525-100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untBright</a:t>
                      </a:r>
                      <a:r>
                        <a:rPr lang="en-US" sz="7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bsolute Counting Bead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ermoFisher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36950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A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Electron Microscopy Solution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15710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DTA Vacutainer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sher Scientific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2-657-32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D Vacutainer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sher Scientific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2-684-26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parin Vacutainer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sher Scientific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7874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BC depletion Bead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em Cell Technologie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170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nexin V Apoptosis Detection Kit with PI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olegend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0932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CompBead Plu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 Bioscience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60497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rmic Acid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illipore Sigma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-18-6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Sodium Chloride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Fisher Scientific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70-10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Sodium Carbonate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fa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esa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97-19-8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Sodium Sulfate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fa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esa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57-82-6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Sodium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zid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Sigma-Aldrich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8032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monium</a:t>
                      </a:r>
                      <a:r>
                        <a:rPr lang="en-US" sz="7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hlorid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ros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Organics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125-02-9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93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tassium Bicarbonate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sher Scientific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8-14-6</a:t>
                      </a:r>
                    </a:p>
                  </a:txBody>
                  <a:tcPr marL="9465" marR="9465" marT="94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04800" y="8500646"/>
            <a:ext cx="41681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: Reagents.</a:t>
            </a:r>
          </a:p>
        </p:txBody>
      </p:sp>
    </p:spTree>
    <p:extLst>
      <p:ext uri="{BB962C8B-B14F-4D97-AF65-F5344CB8AC3E}">
        <p14:creationId xmlns:p14="http://schemas.microsoft.com/office/powerpoint/2010/main" val="1540686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7F933F412904448A6B91CE25BB33676" ma:contentTypeVersion="14" ma:contentTypeDescription="Create a new document." ma:contentTypeScope="" ma:versionID="18ddce794445cebf6c34b6d78ba17f71">
  <xsd:schema xmlns:xsd="http://www.w3.org/2001/XMLSchema" xmlns:xs="http://www.w3.org/2001/XMLSchema" xmlns:p="http://schemas.microsoft.com/office/2006/metadata/properties" xmlns:ns1="http://schemas.microsoft.com/sharepoint/v3" xmlns:ns3="c528ff5c-0e7d-4bbb-8419-61d0564ca801" xmlns:ns4="ee5bd7fd-56d4-4f45-9023-3ad89b6a6a8d" targetNamespace="http://schemas.microsoft.com/office/2006/metadata/properties" ma:root="true" ma:fieldsID="160cbfd15f0c22210ec0a829da2bc5e7" ns1:_="" ns3:_="" ns4:_="">
    <xsd:import namespace="http://schemas.microsoft.com/sharepoint/v3"/>
    <xsd:import namespace="c528ff5c-0e7d-4bbb-8419-61d0564ca801"/>
    <xsd:import namespace="ee5bd7fd-56d4-4f45-9023-3ad89b6a6a8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1:_ip_UnifiedCompliancePolicyProperties" minOccurs="0"/>
                <xsd:element ref="ns1:_ip_UnifiedCompliancePolicyUIAc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0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1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528ff5c-0e7d-4bbb-8419-61d0564ca80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e5bd7fd-56d4-4f45-9023-3ad89b6a6a8d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5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3F9AC47-1640-4D35-B17A-1D944777E8D6}">
  <ds:schemaRefs>
    <ds:schemaRef ds:uri="c528ff5c-0e7d-4bbb-8419-61d0564ca801"/>
    <ds:schemaRef ds:uri="http://www.w3.org/XML/1998/namespace"/>
    <ds:schemaRef ds:uri="http://schemas.microsoft.com/sharepoint/v3"/>
    <ds:schemaRef ds:uri="http://schemas.microsoft.com/office/2006/documentManagement/types"/>
    <ds:schemaRef ds:uri="http://purl.org/dc/terms/"/>
    <ds:schemaRef ds:uri="http://schemas.microsoft.com/office/2006/metadata/properties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ee5bd7fd-56d4-4f45-9023-3ad89b6a6a8d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EF94CB64-540C-4095-9DA3-F8553BD6115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09CCB04-1068-4029-8DE4-9A19B6047BE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c528ff5c-0e7d-4bbb-8419-61d0564ca801"/>
    <ds:schemaRef ds:uri="ee5bd7fd-56d4-4f45-9023-3ad89b6a6a8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2906</TotalTime>
  <Words>985</Words>
  <Application>Microsoft Office PowerPoint</Application>
  <PresentationFormat>Letter Paper (8.5x11 in)</PresentationFormat>
  <Paragraphs>256</Paragraphs>
  <Slides>8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rism 5</vt:lpstr>
      <vt:lpstr>GraphPad Prism 9 Project</vt:lpstr>
      <vt:lpstr>GraphPad Prism 5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AB Dept of Path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elly, Ashley N</dc:creator>
  <cp:lastModifiedBy>Connelly, Ashley N</cp:lastModifiedBy>
  <cp:revision>1389</cp:revision>
  <cp:lastPrinted>2021-02-02T16:38:48Z</cp:lastPrinted>
  <dcterms:created xsi:type="dcterms:W3CDTF">2019-03-18T20:54:56Z</dcterms:created>
  <dcterms:modified xsi:type="dcterms:W3CDTF">2021-12-01T18:22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7F933F412904448A6B91CE25BB33676</vt:lpwstr>
  </property>
</Properties>
</file>